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4" autoAdjust="0"/>
    <p:restoredTop sz="94660"/>
  </p:normalViewPr>
  <p:slideViewPr>
    <p:cSldViewPr snapToGrid="0">
      <p:cViewPr varScale="1">
        <p:scale>
          <a:sx n="88" d="100"/>
          <a:sy n="88" d="100"/>
        </p:scale>
        <p:origin x="141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064C0-57F0-45E3-B320-3D40AB388EE3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B1629-5274-4323-BB8D-7D6FD4ED0A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31049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064C0-57F0-45E3-B320-3D40AB388EE3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B1629-5274-4323-BB8D-7D6FD4ED0A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0058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064C0-57F0-45E3-B320-3D40AB388EE3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B1629-5274-4323-BB8D-7D6FD4ED0A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63944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064C0-57F0-45E3-B320-3D40AB388EE3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B1629-5274-4323-BB8D-7D6FD4ED0A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71199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064C0-57F0-45E3-B320-3D40AB388EE3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B1629-5274-4323-BB8D-7D6FD4ED0A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05207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064C0-57F0-45E3-B320-3D40AB388EE3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B1629-5274-4323-BB8D-7D6FD4ED0A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46784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064C0-57F0-45E3-B320-3D40AB388EE3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B1629-5274-4323-BB8D-7D6FD4ED0A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99789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064C0-57F0-45E3-B320-3D40AB388EE3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B1629-5274-4323-BB8D-7D6FD4ED0A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51212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064C0-57F0-45E3-B320-3D40AB388EE3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B1629-5274-4323-BB8D-7D6FD4ED0A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46619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064C0-57F0-45E3-B320-3D40AB388EE3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B1629-5274-4323-BB8D-7D6FD4ED0A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87268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064C0-57F0-45E3-B320-3D40AB388EE3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B1629-5274-4323-BB8D-7D6FD4ED0A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8249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C064C0-57F0-45E3-B320-3D40AB388EE3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0B1629-5274-4323-BB8D-7D6FD4ED0A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08491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7" Type="http://schemas.openxmlformats.org/officeDocument/2006/relationships/image" Target="../media/image26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png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タイトル 1"/>
          <p:cNvSpPr>
            <a:spLocks noGrp="1"/>
          </p:cNvSpPr>
          <p:nvPr>
            <p:ph type="ctrTitle"/>
          </p:nvPr>
        </p:nvSpPr>
        <p:spPr>
          <a:noFill/>
        </p:spPr>
        <p:txBody>
          <a:bodyPr>
            <a:noAutofit/>
          </a:bodyPr>
          <a:lstStyle/>
          <a:p>
            <a:r>
              <a:rPr lang="en-US" altLang="ja-JP" sz="6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kumimoji="1" lang="en-US" altLang="ja-JP" sz="6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US" altLang="ja-JP" sz="6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re</a:t>
            </a:r>
            <a:r>
              <a:rPr kumimoji="1" lang="en-US" altLang="ja-JP" sz="6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sz="6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56711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コンテンツ プレースホルダー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8915" y="566057"/>
            <a:ext cx="3841332" cy="5975110"/>
          </a:xfrm>
        </p:spPr>
      </p:pic>
      <p:sp>
        <p:nvSpPr>
          <p:cNvPr id="5" name="テキスト ボックス 4"/>
          <p:cNvSpPr txBox="1"/>
          <p:nvPr/>
        </p:nvSpPr>
        <p:spPr>
          <a:xfrm>
            <a:off x="3853322" y="1382485"/>
            <a:ext cx="47160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 smtClean="0"/>
              <a:t>S</a:t>
            </a:r>
            <a:r>
              <a:rPr kumimoji="1" lang="en-US" altLang="ja-JP" sz="2800" baseline="30000" dirty="0" smtClean="0"/>
              <a:t>1</a:t>
            </a:r>
            <a:endParaRPr kumimoji="1" lang="ja-JP" altLang="en-US" sz="2800" baseline="30000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4680525" y="1644095"/>
            <a:ext cx="47160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 smtClean="0"/>
              <a:t>S</a:t>
            </a:r>
            <a:r>
              <a:rPr kumimoji="1" lang="en-US" altLang="ja-JP" sz="2800" baseline="30000" dirty="0" smtClean="0"/>
              <a:t>2</a:t>
            </a:r>
            <a:endParaRPr kumimoji="1" lang="ja-JP" altLang="en-US" sz="2800" baseline="30000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080325" y="2547609"/>
            <a:ext cx="47160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 smtClean="0"/>
              <a:t>S</a:t>
            </a:r>
            <a:r>
              <a:rPr kumimoji="1" lang="en-US" altLang="ja-JP" sz="2800" baseline="30000" dirty="0" smtClean="0"/>
              <a:t>3</a:t>
            </a:r>
            <a:endParaRPr kumimoji="1" lang="ja-JP" altLang="en-US" sz="2800" baseline="30000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2844523" y="4147809"/>
            <a:ext cx="47160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 smtClean="0"/>
              <a:t>S</a:t>
            </a:r>
            <a:r>
              <a:rPr kumimoji="1" lang="en-US" altLang="ja-JP" sz="2800" baseline="30000" dirty="0" smtClean="0"/>
              <a:t>5</a:t>
            </a:r>
            <a:endParaRPr kumimoji="1" lang="ja-JP" altLang="en-US" sz="2800" baseline="30000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5115456" y="2906837"/>
            <a:ext cx="47160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 smtClean="0"/>
              <a:t>S</a:t>
            </a:r>
            <a:r>
              <a:rPr kumimoji="1" lang="en-US" altLang="ja-JP" sz="2800" baseline="30000" dirty="0" smtClean="0"/>
              <a:t>6</a:t>
            </a:r>
            <a:endParaRPr kumimoji="1" lang="ja-JP" altLang="en-US" sz="2800" baseline="30000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5111440" y="3831021"/>
            <a:ext cx="47160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 smtClean="0"/>
              <a:t>S</a:t>
            </a:r>
            <a:r>
              <a:rPr kumimoji="1" lang="en-US" altLang="ja-JP" sz="2800" baseline="30000" dirty="0" smtClean="0"/>
              <a:t>*</a:t>
            </a:r>
            <a:endParaRPr kumimoji="1" lang="ja-JP" altLang="en-US" sz="2800" baseline="30000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4208921" y="4409419"/>
            <a:ext cx="47160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 smtClean="0"/>
              <a:t>S</a:t>
            </a:r>
            <a:r>
              <a:rPr kumimoji="1" lang="en-US" altLang="ja-JP" sz="2800" baseline="30000" dirty="0" smtClean="0"/>
              <a:t>7</a:t>
            </a:r>
            <a:endParaRPr kumimoji="1" lang="ja-JP" altLang="en-US" sz="2800" baseline="30000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5436687" y="5093763"/>
            <a:ext cx="5934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 smtClean="0"/>
              <a:t>S</a:t>
            </a:r>
            <a:r>
              <a:rPr kumimoji="1" lang="en-US" altLang="ja-JP" sz="2800" baseline="30000" dirty="0" smtClean="0"/>
              <a:t>10</a:t>
            </a:r>
            <a:endParaRPr kumimoji="1" lang="ja-JP" altLang="en-US" sz="2800" baseline="30000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647658" y="165093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dirty="0" smtClean="0"/>
              <a:t>　</a:t>
            </a:r>
            <a:endParaRPr kumimoji="1" lang="ja-JP" altLang="en-US" dirty="0"/>
          </a:p>
        </p:txBody>
      </p:sp>
      <p:sp>
        <p:nvSpPr>
          <p:cNvPr id="14" name="タイトル 1"/>
          <p:cNvSpPr>
            <a:spLocks noGrp="1"/>
          </p:cNvSpPr>
          <p:nvPr>
            <p:ph type="title"/>
          </p:nvPr>
        </p:nvSpPr>
        <p:spPr>
          <a:xfrm>
            <a:off x="271564" y="53489"/>
            <a:ext cx="3280365" cy="711198"/>
          </a:xfrm>
          <a:noFill/>
        </p:spPr>
        <p:txBody>
          <a:bodyPr>
            <a:noAutofit/>
          </a:bodyPr>
          <a:lstStyle/>
          <a:p>
            <a:r>
              <a:rPr lang="en-US" altLang="ja-JP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kumimoji="1" lang="en-US" altLang="ja-JP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1 </a:t>
            </a:r>
            <a:endParaRPr kumimoji="1"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874498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84972" y="108726"/>
            <a:ext cx="3180126" cy="425448"/>
          </a:xfrm>
        </p:spPr>
        <p:txBody>
          <a:bodyPr>
            <a:noAutofit/>
          </a:bodyPr>
          <a:lstStyle/>
          <a:p>
            <a:r>
              <a:rPr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kumimoji="1" lang="en-US" altLang="ja-JP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2</a:t>
            </a:r>
            <a:endParaRPr kumimoji="1"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87069" y="551560"/>
            <a:ext cx="37596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3200" dirty="0"/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3089130" y="552080"/>
            <a:ext cx="37596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3200" dirty="0"/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6108134" y="492252"/>
            <a:ext cx="37596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3200" dirty="0"/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112293" y="3778444"/>
            <a:ext cx="37596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kumimoji="1" lang="ja-JP" altLang="en-US" sz="3200" dirty="0"/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3116180" y="3762399"/>
            <a:ext cx="51635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kumimoji="1" lang="ja-JP" altLang="en-US" sz="3200" dirty="0"/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6062204" y="3739478"/>
            <a:ext cx="37596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kumimoji="1" lang="ja-JP" altLang="en-US" sz="3200" dirty="0"/>
          </a:p>
        </p:txBody>
      </p:sp>
      <p:grpSp>
        <p:nvGrpSpPr>
          <p:cNvPr id="23" name="グループ化 22"/>
          <p:cNvGrpSpPr/>
          <p:nvPr/>
        </p:nvGrpSpPr>
        <p:grpSpPr>
          <a:xfrm>
            <a:off x="3501321" y="843948"/>
            <a:ext cx="2532032" cy="2934816"/>
            <a:chOff x="3501321" y="831916"/>
            <a:chExt cx="2532032" cy="2934816"/>
          </a:xfrm>
        </p:grpSpPr>
        <p:grpSp>
          <p:nvGrpSpPr>
            <p:cNvPr id="4" name="グループ化 3"/>
            <p:cNvGrpSpPr>
              <a:grpSpLocks noChangeAspect="1"/>
            </p:cNvGrpSpPr>
            <p:nvPr/>
          </p:nvGrpSpPr>
          <p:grpSpPr>
            <a:xfrm>
              <a:off x="3501321" y="831916"/>
              <a:ext cx="2520000" cy="2556000"/>
              <a:chOff x="6948264" y="1964837"/>
              <a:chExt cx="2038621" cy="1999583"/>
            </a:xfrm>
          </p:grpSpPr>
          <p:pic>
            <p:nvPicPr>
              <p:cNvPr id="5" name="Picture 3"/>
              <p:cNvPicPr>
                <a:picLocks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1999" t="35681" r="39626" b="29317"/>
              <a:stretch/>
            </p:blipFill>
            <p:spPr>
              <a:xfrm>
                <a:off x="6948264" y="1964837"/>
                <a:ext cx="2038621" cy="1999583"/>
              </a:xfrm>
              <a:prstGeom prst="rect">
                <a:avLst/>
              </a:prstGeom>
            </p:spPr>
          </p:pic>
          <p:sp>
            <p:nvSpPr>
              <p:cNvPr id="6" name="テキスト ボックス 5"/>
              <p:cNvSpPr txBox="1"/>
              <p:nvPr/>
            </p:nvSpPr>
            <p:spPr>
              <a:xfrm>
                <a:off x="7739837" y="2934354"/>
                <a:ext cx="288032" cy="2889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ja-JP" altLang="en-US" dirty="0">
                    <a:solidFill>
                      <a:schemeClr val="bg1"/>
                    </a:solidFill>
                  </a:rPr>
                  <a:t>＊</a:t>
                </a:r>
              </a:p>
            </p:txBody>
          </p:sp>
          <p:sp>
            <p:nvSpPr>
              <p:cNvPr id="7" name="テキスト ボックス 6"/>
              <p:cNvSpPr txBox="1"/>
              <p:nvPr/>
            </p:nvSpPr>
            <p:spPr>
              <a:xfrm>
                <a:off x="7403140" y="3055387"/>
                <a:ext cx="288032" cy="2889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ja-JP" altLang="en-US" dirty="0">
                    <a:solidFill>
                      <a:schemeClr val="bg1"/>
                    </a:solidFill>
                  </a:rPr>
                  <a:t>＊</a:t>
                </a:r>
              </a:p>
            </p:txBody>
          </p:sp>
          <p:sp>
            <p:nvSpPr>
              <p:cNvPr id="8" name="テキスト ボックス 7"/>
              <p:cNvSpPr txBox="1"/>
              <p:nvPr/>
            </p:nvSpPr>
            <p:spPr>
              <a:xfrm>
                <a:off x="8467286" y="3059547"/>
                <a:ext cx="468000" cy="2889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US" altLang="ja-JP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endParaRPr lang="ja-JP" altLang="en-US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9" name="直線コネクタ 8"/>
              <p:cNvCxnSpPr/>
              <p:nvPr/>
            </p:nvCxnSpPr>
            <p:spPr bwMode="auto">
              <a:xfrm flipH="1" flipV="1">
                <a:off x="7956376" y="3099250"/>
                <a:ext cx="540112" cy="113238"/>
              </a:xfrm>
              <a:prstGeom prst="line">
                <a:avLst/>
              </a:prstGeom>
              <a:solidFill>
                <a:schemeClr val="accent1"/>
              </a:solidFill>
              <a:ln w="190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10" name="テキスト ボックス 9"/>
              <p:cNvSpPr txBox="1"/>
              <p:nvPr/>
            </p:nvSpPr>
            <p:spPr>
              <a:xfrm>
                <a:off x="7697545" y="3572384"/>
                <a:ext cx="468000" cy="2889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US" altLang="ja-JP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endParaRPr lang="ja-JP" altLang="en-US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1" name="直線コネクタ 10"/>
              <p:cNvCxnSpPr/>
              <p:nvPr/>
            </p:nvCxnSpPr>
            <p:spPr bwMode="auto">
              <a:xfrm flipH="1" flipV="1">
                <a:off x="7586500" y="3262550"/>
                <a:ext cx="216128" cy="359773"/>
              </a:xfrm>
              <a:prstGeom prst="line">
                <a:avLst/>
              </a:prstGeom>
              <a:solidFill>
                <a:schemeClr val="accent1"/>
              </a:solidFill>
              <a:ln w="190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</p:grpSp>
        <p:sp>
          <p:nvSpPr>
            <p:cNvPr id="22" name="テキスト ボックス 21"/>
            <p:cNvSpPr txBox="1"/>
            <p:nvPr/>
          </p:nvSpPr>
          <p:spPr>
            <a:xfrm>
              <a:off x="3513353" y="3397400"/>
              <a:ext cx="2520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wo stems; 69.6%</a:t>
              </a:r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5" name="グループ化 24"/>
          <p:cNvGrpSpPr/>
          <p:nvPr/>
        </p:nvGrpSpPr>
        <p:grpSpPr>
          <a:xfrm>
            <a:off x="6441273" y="797852"/>
            <a:ext cx="2547846" cy="2928773"/>
            <a:chOff x="6236730" y="797852"/>
            <a:chExt cx="2547846" cy="2928773"/>
          </a:xfrm>
        </p:grpSpPr>
        <p:grpSp>
          <p:nvGrpSpPr>
            <p:cNvPr id="28" name="グループ化 27"/>
            <p:cNvGrpSpPr>
              <a:grpSpLocks noChangeAspect="1"/>
            </p:cNvGrpSpPr>
            <p:nvPr/>
          </p:nvGrpSpPr>
          <p:grpSpPr>
            <a:xfrm>
              <a:off x="6236730" y="797852"/>
              <a:ext cx="2536314" cy="2555999"/>
              <a:chOff x="288589" y="2588617"/>
              <a:chExt cx="2742484" cy="3226667"/>
            </a:xfrm>
          </p:grpSpPr>
          <p:pic>
            <p:nvPicPr>
              <p:cNvPr id="29" name="Picture 3"/>
              <p:cNvPicPr>
                <a:picLocks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6058" t="43589" r="38952" b="24591"/>
              <a:stretch/>
            </p:blipFill>
            <p:spPr>
              <a:xfrm>
                <a:off x="288589" y="2588617"/>
                <a:ext cx="2724844" cy="3226667"/>
              </a:xfrm>
              <a:prstGeom prst="rect">
                <a:avLst/>
              </a:prstGeom>
            </p:spPr>
          </p:pic>
          <p:sp>
            <p:nvSpPr>
              <p:cNvPr id="30" name="テキスト ボックス 29"/>
              <p:cNvSpPr txBox="1"/>
              <p:nvPr/>
            </p:nvSpPr>
            <p:spPr>
              <a:xfrm>
                <a:off x="1524497" y="3535336"/>
                <a:ext cx="396044" cy="4662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ja-JP" altLang="en-US" dirty="0">
                    <a:solidFill>
                      <a:schemeClr val="bg1"/>
                    </a:solidFill>
                  </a:rPr>
                  <a:t>＊</a:t>
                </a:r>
              </a:p>
            </p:txBody>
          </p:sp>
          <p:sp>
            <p:nvSpPr>
              <p:cNvPr id="31" name="テキスト ボックス 30"/>
              <p:cNvSpPr txBox="1"/>
              <p:nvPr/>
            </p:nvSpPr>
            <p:spPr>
              <a:xfrm>
                <a:off x="945580" y="3622691"/>
                <a:ext cx="288032" cy="4662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ja-JP" altLang="en-US" dirty="0">
                    <a:solidFill>
                      <a:schemeClr val="bg1"/>
                    </a:solidFill>
                  </a:rPr>
                  <a:t>＊</a:t>
                </a:r>
              </a:p>
            </p:txBody>
          </p:sp>
          <p:cxnSp>
            <p:nvCxnSpPr>
              <p:cNvPr id="33" name="直線コネクタ 32"/>
              <p:cNvCxnSpPr/>
              <p:nvPr/>
            </p:nvCxnSpPr>
            <p:spPr bwMode="auto">
              <a:xfrm flipH="1" flipV="1">
                <a:off x="1811869" y="3777524"/>
                <a:ext cx="713745" cy="100664"/>
              </a:xfrm>
              <a:prstGeom prst="line">
                <a:avLst/>
              </a:prstGeom>
              <a:solidFill>
                <a:schemeClr val="accent1"/>
              </a:solidFill>
              <a:ln w="190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34" name="テキスト ボックス 33"/>
              <p:cNvSpPr txBox="1"/>
              <p:nvPr/>
            </p:nvSpPr>
            <p:spPr>
              <a:xfrm>
                <a:off x="2491073" y="3660993"/>
                <a:ext cx="540000" cy="4662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US" altLang="ja-JP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endParaRPr lang="ja-JP" altLang="en-US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5" name="直線コネクタ 34"/>
              <p:cNvCxnSpPr/>
              <p:nvPr/>
            </p:nvCxnSpPr>
            <p:spPr bwMode="auto">
              <a:xfrm flipH="1" flipV="1">
                <a:off x="1194584" y="3894545"/>
                <a:ext cx="544359" cy="1388630"/>
              </a:xfrm>
              <a:prstGeom prst="line">
                <a:avLst/>
              </a:prstGeom>
              <a:solidFill>
                <a:schemeClr val="accent1"/>
              </a:solidFill>
              <a:ln w="190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36" name="テキスト ボックス 35"/>
              <p:cNvSpPr txBox="1"/>
              <p:nvPr/>
            </p:nvSpPr>
            <p:spPr>
              <a:xfrm>
                <a:off x="1645484" y="5249246"/>
                <a:ext cx="720081" cy="4662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US" altLang="ja-JP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ja-JP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7" name="直線コネクタ 36"/>
              <p:cNvCxnSpPr/>
              <p:nvPr/>
            </p:nvCxnSpPr>
            <p:spPr bwMode="auto">
              <a:xfrm flipH="1" flipV="1">
                <a:off x="1090873" y="4515314"/>
                <a:ext cx="103710" cy="786538"/>
              </a:xfrm>
              <a:prstGeom prst="line">
                <a:avLst/>
              </a:prstGeom>
              <a:solidFill>
                <a:schemeClr val="accent1"/>
              </a:solidFill>
              <a:ln w="190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38" name="テキスト ボックス 37"/>
              <p:cNvSpPr txBox="1"/>
              <p:nvPr/>
            </p:nvSpPr>
            <p:spPr>
              <a:xfrm>
                <a:off x="991567" y="5231960"/>
                <a:ext cx="648071" cy="4662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US" altLang="ja-JP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ja-JP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55" name="テキスト ボックス 54"/>
            <p:cNvSpPr txBox="1"/>
            <p:nvPr/>
          </p:nvSpPr>
          <p:spPr>
            <a:xfrm>
              <a:off x="6774770" y="2076828"/>
              <a:ext cx="3329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dirty="0">
                  <a:solidFill>
                    <a:schemeClr val="bg1"/>
                  </a:solidFill>
                </a:rPr>
                <a:t>＊</a:t>
              </a:r>
            </a:p>
          </p:txBody>
        </p:sp>
        <p:sp>
          <p:nvSpPr>
            <p:cNvPr id="62" name="テキスト ボックス 61"/>
            <p:cNvSpPr txBox="1"/>
            <p:nvPr/>
          </p:nvSpPr>
          <p:spPr>
            <a:xfrm>
              <a:off x="6264576" y="3357293"/>
              <a:ext cx="2520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ree stems; 1.1%</a:t>
              </a:r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7" name="グループ化 26"/>
          <p:cNvGrpSpPr/>
          <p:nvPr/>
        </p:nvGrpSpPr>
        <p:grpSpPr>
          <a:xfrm>
            <a:off x="441285" y="3928881"/>
            <a:ext cx="2555371" cy="2889866"/>
            <a:chOff x="681922" y="4037169"/>
            <a:chExt cx="2555371" cy="2889866"/>
          </a:xfrm>
        </p:grpSpPr>
        <p:grpSp>
          <p:nvGrpSpPr>
            <p:cNvPr id="12" name="グループ化 11"/>
            <p:cNvGrpSpPr>
              <a:grpSpLocks noChangeAspect="1"/>
            </p:cNvGrpSpPr>
            <p:nvPr/>
          </p:nvGrpSpPr>
          <p:grpSpPr>
            <a:xfrm>
              <a:off x="717293" y="4037169"/>
              <a:ext cx="2520000" cy="2520000"/>
              <a:chOff x="6948265" y="4470258"/>
              <a:chExt cx="2211417" cy="1918081"/>
            </a:xfrm>
          </p:grpSpPr>
          <p:pic>
            <p:nvPicPr>
              <p:cNvPr id="13" name="Picture 3"/>
              <p:cNvPicPr>
                <a:picLocks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1250" t="27679" r="44993" b="43729"/>
              <a:stretch/>
            </p:blipFill>
            <p:spPr>
              <a:xfrm>
                <a:off x="6948265" y="4470258"/>
                <a:ext cx="2211417" cy="1918081"/>
              </a:xfrm>
              <a:prstGeom prst="rect">
                <a:avLst/>
              </a:prstGeom>
            </p:spPr>
          </p:pic>
          <p:sp>
            <p:nvSpPr>
              <p:cNvPr id="14" name="テキスト ボックス 13"/>
              <p:cNvSpPr txBox="1"/>
              <p:nvPr/>
            </p:nvSpPr>
            <p:spPr>
              <a:xfrm>
                <a:off x="8029065" y="5392995"/>
                <a:ext cx="288032" cy="2811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ja-JP" altLang="en-US" dirty="0">
                    <a:solidFill>
                      <a:schemeClr val="bg1"/>
                    </a:solidFill>
                  </a:rPr>
                  <a:t>＊</a:t>
                </a:r>
              </a:p>
            </p:txBody>
          </p:sp>
          <p:sp>
            <p:nvSpPr>
              <p:cNvPr id="15" name="テキスト ボックス 14"/>
              <p:cNvSpPr txBox="1"/>
              <p:nvPr/>
            </p:nvSpPr>
            <p:spPr>
              <a:xfrm>
                <a:off x="7215613" y="4671454"/>
                <a:ext cx="620320" cy="2811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</a:t>
                </a:r>
                <a:r>
                  <a:rPr lang="en-US" altLang="ja-JP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+5</a:t>
                </a:r>
                <a:endParaRPr lang="ja-JP" altLang="en-US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6" name="直線コネクタ 15"/>
              <p:cNvCxnSpPr/>
              <p:nvPr/>
            </p:nvCxnSpPr>
            <p:spPr bwMode="auto">
              <a:xfrm>
                <a:off x="7531983" y="4901720"/>
                <a:ext cx="643017" cy="599741"/>
              </a:xfrm>
              <a:prstGeom prst="line">
                <a:avLst/>
              </a:prstGeom>
              <a:solidFill>
                <a:schemeClr val="accent1"/>
              </a:solidFill>
              <a:ln w="190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</p:grpSp>
        <p:sp>
          <p:nvSpPr>
            <p:cNvPr id="63" name="テキスト ボックス 62"/>
            <p:cNvSpPr txBox="1"/>
            <p:nvPr/>
          </p:nvSpPr>
          <p:spPr>
            <a:xfrm>
              <a:off x="681922" y="6557703"/>
              <a:ext cx="2520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ngle stem; 67.7%</a:t>
              </a:r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8" name="グループ化 17"/>
          <p:cNvGrpSpPr/>
          <p:nvPr/>
        </p:nvGrpSpPr>
        <p:grpSpPr>
          <a:xfrm>
            <a:off x="465956" y="841131"/>
            <a:ext cx="2552457" cy="2899284"/>
            <a:chOff x="563723" y="861948"/>
            <a:chExt cx="2552457" cy="2899284"/>
          </a:xfrm>
        </p:grpSpPr>
        <p:pic>
          <p:nvPicPr>
            <p:cNvPr id="43" name="Picture 3"/>
            <p:cNvPicPr>
              <a:picLocks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887" t="36626" r="41855" b="36019"/>
            <a:stretch/>
          </p:blipFill>
          <p:spPr>
            <a:xfrm>
              <a:off x="563723" y="861948"/>
              <a:ext cx="2520000" cy="2520000"/>
            </a:xfrm>
            <a:prstGeom prst="rect">
              <a:avLst/>
            </a:prstGeom>
          </p:spPr>
        </p:pic>
        <p:sp>
          <p:nvSpPr>
            <p:cNvPr id="44" name="テキスト ボックス 43"/>
            <p:cNvSpPr txBox="1"/>
            <p:nvPr/>
          </p:nvSpPr>
          <p:spPr>
            <a:xfrm>
              <a:off x="1964875" y="1917000"/>
              <a:ext cx="35604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dirty="0">
                  <a:solidFill>
                    <a:schemeClr val="bg1"/>
                  </a:solidFill>
                </a:rPr>
                <a:t>＊</a:t>
              </a:r>
            </a:p>
          </p:txBody>
        </p:sp>
        <p:sp>
          <p:nvSpPr>
            <p:cNvPr id="45" name="テキスト ボックス 44"/>
            <p:cNvSpPr txBox="1"/>
            <p:nvPr/>
          </p:nvSpPr>
          <p:spPr>
            <a:xfrm>
              <a:off x="1763914" y="3026946"/>
              <a:ext cx="90446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lang="en-US" altLang="ja-JP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A</a:t>
              </a:r>
              <a:r>
                <a:rPr lang="en-US" altLang="ja-JP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lang="ja-JP" alt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6" name="直線コネクタ 45"/>
            <p:cNvCxnSpPr/>
            <p:nvPr/>
          </p:nvCxnSpPr>
          <p:spPr bwMode="auto">
            <a:xfrm flipV="1">
              <a:off x="2020312" y="2165260"/>
              <a:ext cx="142751" cy="861152"/>
            </a:xfrm>
            <a:prstGeom prst="line">
              <a:avLst/>
            </a:prstGeom>
            <a:solidFill>
              <a:schemeClr val="accent1"/>
            </a:solidFill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17" name="角丸四角形 16"/>
            <p:cNvSpPr/>
            <p:nvPr/>
          </p:nvSpPr>
          <p:spPr>
            <a:xfrm>
              <a:off x="2961285" y="2905465"/>
              <a:ext cx="154895" cy="494483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9" name="角丸四角形 48"/>
            <p:cNvSpPr/>
            <p:nvPr/>
          </p:nvSpPr>
          <p:spPr>
            <a:xfrm>
              <a:off x="718302" y="2568629"/>
              <a:ext cx="357074" cy="247399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0" name="テキスト ボックス 49"/>
            <p:cNvSpPr txBox="1"/>
            <p:nvPr/>
          </p:nvSpPr>
          <p:spPr>
            <a:xfrm>
              <a:off x="574609" y="3391900"/>
              <a:ext cx="2520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ngle stem; 29.3%</a:t>
              </a:r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7" name="テキスト ボックス 46"/>
          <p:cNvSpPr txBox="1"/>
          <p:nvPr/>
        </p:nvSpPr>
        <p:spPr>
          <a:xfrm>
            <a:off x="3528274" y="6452957"/>
            <a:ext cx="252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wo stems; 30.7%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6413248" y="6445866"/>
            <a:ext cx="252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ree stems; 1.6%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1" name="Picture 2"/>
          <p:cNvPicPr>
            <a:picLocks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405" t="37899" r="39640" b="25382"/>
          <a:stretch/>
        </p:blipFill>
        <p:spPr bwMode="auto">
          <a:xfrm>
            <a:off x="3513353" y="3925866"/>
            <a:ext cx="2520000" cy="252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3" name="テキスト ボックス 52"/>
          <p:cNvSpPr txBox="1"/>
          <p:nvPr/>
        </p:nvSpPr>
        <p:spPr>
          <a:xfrm>
            <a:off x="4304658" y="5252835"/>
            <a:ext cx="328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>
                <a:solidFill>
                  <a:schemeClr val="bg1"/>
                </a:solidFill>
              </a:rPr>
              <a:t>＊</a:t>
            </a: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4707429" y="5143978"/>
            <a:ext cx="328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>
                <a:solidFill>
                  <a:schemeClr val="bg1"/>
                </a:solidFill>
              </a:rPr>
              <a:t>＊</a:t>
            </a:r>
          </a:p>
        </p:txBody>
      </p:sp>
      <p:cxnSp>
        <p:nvCxnSpPr>
          <p:cNvPr id="64" name="直線コネクタ 63"/>
          <p:cNvCxnSpPr/>
          <p:nvPr/>
        </p:nvCxnSpPr>
        <p:spPr bwMode="auto">
          <a:xfrm>
            <a:off x="3892395" y="4639249"/>
            <a:ext cx="561292" cy="762191"/>
          </a:xfrm>
          <a:prstGeom prst="line">
            <a:avLst/>
          </a:prstGeom>
          <a:solidFill>
            <a:schemeClr val="accent1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65" name="テキスト ボックス 64"/>
          <p:cNvSpPr txBox="1"/>
          <p:nvPr/>
        </p:nvSpPr>
        <p:spPr>
          <a:xfrm>
            <a:off x="3601001" y="4305155"/>
            <a:ext cx="4761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ja-JP" altLang="en-US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5495109" y="4457555"/>
            <a:ext cx="459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ja-JP" altLang="en-US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7" name="直線コネクタ 66"/>
          <p:cNvCxnSpPr/>
          <p:nvPr/>
        </p:nvCxnSpPr>
        <p:spPr bwMode="auto">
          <a:xfrm flipH="1">
            <a:off x="4954141" y="4705265"/>
            <a:ext cx="598209" cy="598203"/>
          </a:xfrm>
          <a:prstGeom prst="line">
            <a:avLst/>
          </a:prstGeom>
          <a:solidFill>
            <a:schemeClr val="accent1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pic>
        <p:nvPicPr>
          <p:cNvPr id="68" name="Picture 2"/>
          <p:cNvPicPr>
            <a:picLocks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673" t="30188" r="41533" b="34112"/>
          <a:stretch/>
        </p:blipFill>
        <p:spPr bwMode="auto">
          <a:xfrm>
            <a:off x="6438172" y="3920632"/>
            <a:ext cx="2520000" cy="252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9" name="テキスト ボックス 68"/>
          <p:cNvSpPr txBox="1"/>
          <p:nvPr/>
        </p:nvSpPr>
        <p:spPr>
          <a:xfrm>
            <a:off x="7246306" y="4430820"/>
            <a:ext cx="3282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600" dirty="0">
                <a:solidFill>
                  <a:schemeClr val="bg1"/>
                </a:solidFill>
              </a:rPr>
              <a:t>＊</a:t>
            </a:r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7586556" y="4563952"/>
            <a:ext cx="3282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600" dirty="0">
                <a:solidFill>
                  <a:schemeClr val="bg1"/>
                </a:solidFill>
              </a:rPr>
              <a:t>＊</a:t>
            </a:r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8062730" y="5108527"/>
            <a:ext cx="328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>
                <a:solidFill>
                  <a:schemeClr val="bg1"/>
                </a:solidFill>
              </a:rPr>
              <a:t>＊</a:t>
            </a:r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6572797" y="4261613"/>
            <a:ext cx="5927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7084425" y="4022122"/>
            <a:ext cx="5927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4" name="直線コネクタ 73"/>
          <p:cNvCxnSpPr/>
          <p:nvPr/>
        </p:nvCxnSpPr>
        <p:spPr bwMode="auto">
          <a:xfrm>
            <a:off x="7079816" y="4495742"/>
            <a:ext cx="302431" cy="78895"/>
          </a:xfrm>
          <a:prstGeom prst="line">
            <a:avLst/>
          </a:prstGeom>
          <a:solidFill>
            <a:schemeClr val="accent1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5" name="直線コネクタ 74"/>
          <p:cNvCxnSpPr/>
          <p:nvPr/>
        </p:nvCxnSpPr>
        <p:spPr bwMode="auto">
          <a:xfrm>
            <a:off x="7558346" y="4334118"/>
            <a:ext cx="189543" cy="349878"/>
          </a:xfrm>
          <a:prstGeom prst="line">
            <a:avLst/>
          </a:prstGeom>
          <a:solidFill>
            <a:schemeClr val="accent1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76" name="テキスト ボックス 75"/>
          <p:cNvSpPr txBox="1"/>
          <p:nvPr/>
        </p:nvSpPr>
        <p:spPr>
          <a:xfrm>
            <a:off x="8358050" y="6030400"/>
            <a:ext cx="459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ja-JP" altLang="en-US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7" name="直線コネクタ 76"/>
          <p:cNvCxnSpPr/>
          <p:nvPr/>
        </p:nvCxnSpPr>
        <p:spPr bwMode="auto">
          <a:xfrm>
            <a:off x="8268714" y="5341402"/>
            <a:ext cx="234199" cy="765440"/>
          </a:xfrm>
          <a:prstGeom prst="line">
            <a:avLst/>
          </a:prstGeom>
          <a:solidFill>
            <a:schemeClr val="accent1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78" name="テキスト ボックス 77"/>
          <p:cNvSpPr txBox="1"/>
          <p:nvPr/>
        </p:nvSpPr>
        <p:spPr>
          <a:xfrm>
            <a:off x="7812358" y="4240462"/>
            <a:ext cx="328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>
                <a:solidFill>
                  <a:schemeClr val="bg1"/>
                </a:solidFill>
              </a:rPr>
              <a:t>＊</a:t>
            </a:r>
          </a:p>
        </p:txBody>
      </p:sp>
      <p:sp>
        <p:nvSpPr>
          <p:cNvPr id="79" name="テキスト ボックス 78"/>
          <p:cNvSpPr txBox="1"/>
          <p:nvPr/>
        </p:nvSpPr>
        <p:spPr>
          <a:xfrm>
            <a:off x="8197718" y="3902380"/>
            <a:ext cx="772047" cy="27979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. cent</a:t>
            </a:r>
            <a:endParaRPr lang="ja-JP" altLang="en-US" sz="16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0" name="直線コネクタ 79"/>
          <p:cNvCxnSpPr/>
          <p:nvPr/>
        </p:nvCxnSpPr>
        <p:spPr bwMode="auto">
          <a:xfrm flipV="1">
            <a:off x="8041573" y="4186488"/>
            <a:ext cx="181332" cy="196824"/>
          </a:xfrm>
          <a:prstGeom prst="line">
            <a:avLst/>
          </a:prstGeom>
          <a:solidFill>
            <a:schemeClr val="accent1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</p:spTree>
    <p:extLst>
      <p:ext uri="{BB962C8B-B14F-4D97-AF65-F5344CB8AC3E}">
        <p14:creationId xmlns:p14="http://schemas.microsoft.com/office/powerpoint/2010/main" val="33828117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482" t="44457" r="49263" b="25291"/>
          <a:stretch/>
        </p:blipFill>
        <p:spPr bwMode="auto">
          <a:xfrm>
            <a:off x="2594279" y="1274103"/>
            <a:ext cx="3677160" cy="39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タイトル 1"/>
          <p:cNvSpPr>
            <a:spLocks noGrp="1"/>
          </p:cNvSpPr>
          <p:nvPr>
            <p:ph type="title"/>
          </p:nvPr>
        </p:nvSpPr>
        <p:spPr>
          <a:xfrm>
            <a:off x="271564" y="53489"/>
            <a:ext cx="3222750" cy="711198"/>
          </a:xfrm>
          <a:noFill/>
        </p:spPr>
        <p:txBody>
          <a:bodyPr>
            <a:noAutofit/>
          </a:bodyPr>
          <a:lstStyle/>
          <a:p>
            <a:r>
              <a:rPr lang="en-US" altLang="ja-JP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kumimoji="1" lang="en-US" altLang="ja-JP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3 </a:t>
            </a:r>
            <a:endParaRPr kumimoji="1"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4633064" y="3327790"/>
            <a:ext cx="3162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600" dirty="0">
                <a:solidFill>
                  <a:schemeClr val="bg1"/>
                </a:solidFill>
              </a:rPr>
              <a:t>＊</a:t>
            </a: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5468194" y="4526248"/>
            <a:ext cx="608139" cy="30523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7a</a:t>
            </a:r>
            <a:endParaRPr lang="ja-JP" altLang="en-US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直線コネクタ 7"/>
          <p:cNvCxnSpPr/>
          <p:nvPr/>
        </p:nvCxnSpPr>
        <p:spPr bwMode="auto">
          <a:xfrm>
            <a:off x="4663636" y="3897176"/>
            <a:ext cx="897192" cy="629072"/>
          </a:xfrm>
          <a:prstGeom prst="line">
            <a:avLst/>
          </a:prstGeom>
          <a:solidFill>
            <a:schemeClr val="accent1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9" name="テキスト ボックス 8"/>
          <p:cNvSpPr txBox="1"/>
          <p:nvPr/>
        </p:nvSpPr>
        <p:spPr>
          <a:xfrm>
            <a:off x="4459099" y="3743288"/>
            <a:ext cx="3162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400" dirty="0">
                <a:solidFill>
                  <a:schemeClr val="bg1"/>
                </a:solidFill>
              </a:rPr>
              <a:t>＊</a:t>
            </a: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5468194" y="4003212"/>
            <a:ext cx="552854" cy="3052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4954108" y="2477446"/>
            <a:ext cx="3162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>
                <a:solidFill>
                  <a:schemeClr val="bg1"/>
                </a:solidFill>
              </a:rPr>
              <a:t>＊</a:t>
            </a: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2817381" y="2846778"/>
            <a:ext cx="869765" cy="30523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A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ja-JP" altLang="en-US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" name="直線コネクタ 12"/>
          <p:cNvCxnSpPr/>
          <p:nvPr/>
        </p:nvCxnSpPr>
        <p:spPr bwMode="auto">
          <a:xfrm flipV="1">
            <a:off x="3572540" y="2652622"/>
            <a:ext cx="1531466" cy="271100"/>
          </a:xfrm>
          <a:prstGeom prst="line">
            <a:avLst/>
          </a:prstGeom>
          <a:solidFill>
            <a:schemeClr val="accent1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14" name="テキスト ボックス 13"/>
          <p:cNvSpPr txBox="1"/>
          <p:nvPr/>
        </p:nvSpPr>
        <p:spPr>
          <a:xfrm>
            <a:off x="3252264" y="5264463"/>
            <a:ext cx="252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 from A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0.4%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" name="直線コネクタ 14"/>
          <p:cNvCxnSpPr/>
          <p:nvPr/>
        </p:nvCxnSpPr>
        <p:spPr bwMode="auto">
          <a:xfrm>
            <a:off x="4838765" y="3554633"/>
            <a:ext cx="751606" cy="601195"/>
          </a:xfrm>
          <a:prstGeom prst="line">
            <a:avLst/>
          </a:prstGeom>
          <a:solidFill>
            <a:schemeClr val="accent1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</p:spTree>
    <p:extLst>
      <p:ext uri="{BB962C8B-B14F-4D97-AF65-F5344CB8AC3E}">
        <p14:creationId xmlns:p14="http://schemas.microsoft.com/office/powerpoint/2010/main" val="24461150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56623" y="99031"/>
            <a:ext cx="3584005" cy="711198"/>
          </a:xfrm>
        </p:spPr>
        <p:txBody>
          <a:bodyPr>
            <a:noAutofit/>
          </a:bodyPr>
          <a:lstStyle/>
          <a:p>
            <a:r>
              <a:rPr lang="en-US" altLang="ja-JP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kumimoji="1" lang="en-US" altLang="ja-JP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4 </a:t>
            </a:r>
            <a:endParaRPr kumimoji="1"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246781" y="768697"/>
            <a:ext cx="37596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3200" dirty="0"/>
          </a:p>
        </p:txBody>
      </p:sp>
      <p:sp>
        <p:nvSpPr>
          <p:cNvPr id="4" name="テキスト ボックス 3"/>
          <p:cNvSpPr txBox="1"/>
          <p:nvPr/>
        </p:nvSpPr>
        <p:spPr>
          <a:xfrm>
            <a:off x="4679441" y="768698"/>
            <a:ext cx="37596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3200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224253" y="5301700"/>
            <a:ext cx="252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ngle stem; 19.3%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5642284" y="5312333"/>
            <a:ext cx="27496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wo stems; 1.1%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815" t="32889" r="47059" b="32395"/>
          <a:stretch/>
        </p:blipFill>
        <p:spPr bwMode="auto">
          <a:xfrm>
            <a:off x="434765" y="1278065"/>
            <a:ext cx="3960000" cy="39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テキスト ボックス 10"/>
          <p:cNvSpPr txBox="1"/>
          <p:nvPr/>
        </p:nvSpPr>
        <p:spPr>
          <a:xfrm>
            <a:off x="1890882" y="3205614"/>
            <a:ext cx="3162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>
                <a:solidFill>
                  <a:schemeClr val="bg1"/>
                </a:solidFill>
              </a:rPr>
              <a:t>＊</a:t>
            </a: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235863" y="2644560"/>
            <a:ext cx="502596" cy="3052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*</a:t>
            </a:r>
            <a:endParaRPr lang="ja-JP" altLang="en-US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" name="直線コネクタ 12"/>
          <p:cNvCxnSpPr/>
          <p:nvPr/>
        </p:nvCxnSpPr>
        <p:spPr bwMode="auto">
          <a:xfrm>
            <a:off x="1605448" y="2878121"/>
            <a:ext cx="435622" cy="473642"/>
          </a:xfrm>
          <a:prstGeom prst="line">
            <a:avLst/>
          </a:prstGeom>
          <a:solidFill>
            <a:schemeClr val="accent1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16" name="テキスト ボックス 15"/>
          <p:cNvSpPr txBox="1"/>
          <p:nvPr/>
        </p:nvSpPr>
        <p:spPr>
          <a:xfrm>
            <a:off x="2893538" y="3397053"/>
            <a:ext cx="3162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>
                <a:solidFill>
                  <a:schemeClr val="bg1"/>
                </a:solidFill>
              </a:rPr>
              <a:t>＊</a:t>
            </a: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3712592" y="4263661"/>
            <a:ext cx="608139" cy="30523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7a</a:t>
            </a:r>
            <a:endParaRPr lang="ja-JP" altLang="en-US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" name="直線コネクタ 17"/>
          <p:cNvCxnSpPr/>
          <p:nvPr/>
        </p:nvCxnSpPr>
        <p:spPr bwMode="auto">
          <a:xfrm>
            <a:off x="3161128" y="3651843"/>
            <a:ext cx="558073" cy="611818"/>
          </a:xfrm>
          <a:prstGeom prst="line">
            <a:avLst/>
          </a:prstGeom>
          <a:solidFill>
            <a:schemeClr val="accent1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20" name="テキスト ボックス 19"/>
          <p:cNvSpPr txBox="1"/>
          <p:nvPr/>
        </p:nvSpPr>
        <p:spPr>
          <a:xfrm>
            <a:off x="2218601" y="1808753"/>
            <a:ext cx="4136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>
                <a:solidFill>
                  <a:schemeClr val="bg1"/>
                </a:solidFill>
              </a:rPr>
              <a:t>＊</a:t>
            </a: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1171571" y="2144111"/>
            <a:ext cx="456905" cy="2774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ja-JP" altLang="en-US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直線コネクタ 22"/>
          <p:cNvCxnSpPr/>
          <p:nvPr/>
        </p:nvCxnSpPr>
        <p:spPr bwMode="auto">
          <a:xfrm flipV="1">
            <a:off x="1600683" y="2037640"/>
            <a:ext cx="781709" cy="245214"/>
          </a:xfrm>
          <a:prstGeom prst="line">
            <a:avLst/>
          </a:prstGeom>
          <a:solidFill>
            <a:schemeClr val="accent1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pic>
        <p:nvPicPr>
          <p:cNvPr id="33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985" t="39447" r="49697" b="22900"/>
          <a:stretch/>
        </p:blipFill>
        <p:spPr bwMode="auto">
          <a:xfrm>
            <a:off x="4924484" y="1278058"/>
            <a:ext cx="3960000" cy="39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4" name="テキスト ボックス 33"/>
          <p:cNvSpPr txBox="1"/>
          <p:nvPr/>
        </p:nvSpPr>
        <p:spPr>
          <a:xfrm>
            <a:off x="6853692" y="1580297"/>
            <a:ext cx="4136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>
                <a:solidFill>
                  <a:schemeClr val="bg1"/>
                </a:solidFill>
              </a:rPr>
              <a:t>＊</a:t>
            </a: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5485310" y="2321247"/>
            <a:ext cx="456905" cy="3052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ja-JP" altLang="en-US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直線コネクタ 35"/>
          <p:cNvCxnSpPr/>
          <p:nvPr/>
        </p:nvCxnSpPr>
        <p:spPr bwMode="auto">
          <a:xfrm flipV="1">
            <a:off x="5877176" y="1787120"/>
            <a:ext cx="1122605" cy="634476"/>
          </a:xfrm>
          <a:prstGeom prst="line">
            <a:avLst/>
          </a:prstGeom>
          <a:solidFill>
            <a:schemeClr val="accent1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38" name="テキスト ボックス 37"/>
          <p:cNvSpPr txBox="1"/>
          <p:nvPr/>
        </p:nvSpPr>
        <p:spPr>
          <a:xfrm>
            <a:off x="7673166" y="2427845"/>
            <a:ext cx="3162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>
                <a:solidFill>
                  <a:schemeClr val="bg1"/>
                </a:solidFill>
              </a:rPr>
              <a:t>＊</a:t>
            </a: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8186515" y="4346508"/>
            <a:ext cx="608139" cy="30523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7a</a:t>
            </a:r>
            <a:endParaRPr lang="ja-JP" altLang="en-US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0" name="直線コネクタ 39"/>
          <p:cNvCxnSpPr/>
          <p:nvPr/>
        </p:nvCxnSpPr>
        <p:spPr bwMode="auto">
          <a:xfrm>
            <a:off x="7922505" y="2644560"/>
            <a:ext cx="264010" cy="1726098"/>
          </a:xfrm>
          <a:prstGeom prst="line">
            <a:avLst/>
          </a:prstGeom>
          <a:solidFill>
            <a:schemeClr val="accent1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42" name="テキスト ボックス 41"/>
          <p:cNvSpPr txBox="1"/>
          <p:nvPr/>
        </p:nvSpPr>
        <p:spPr>
          <a:xfrm>
            <a:off x="6095416" y="3193508"/>
            <a:ext cx="3162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>
                <a:solidFill>
                  <a:schemeClr val="bg1"/>
                </a:solidFill>
              </a:rPr>
              <a:t>＊</a:t>
            </a: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5877176" y="3695792"/>
            <a:ext cx="3162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600" dirty="0">
                <a:solidFill>
                  <a:schemeClr val="bg1"/>
                </a:solidFill>
              </a:rPr>
              <a:t>＊</a:t>
            </a: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5211167" y="4153976"/>
            <a:ext cx="502596" cy="3052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*</a:t>
            </a:r>
            <a:endParaRPr lang="ja-JP" altLang="en-US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797576" y="4093173"/>
            <a:ext cx="456905" cy="27748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*</a:t>
            </a:r>
            <a:endParaRPr lang="ja-JP" altLang="en-US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5" name="直線コネクタ 44"/>
          <p:cNvCxnSpPr/>
          <p:nvPr/>
        </p:nvCxnSpPr>
        <p:spPr bwMode="auto">
          <a:xfrm flipV="1">
            <a:off x="1214182" y="3550752"/>
            <a:ext cx="885387" cy="522273"/>
          </a:xfrm>
          <a:prstGeom prst="line">
            <a:avLst/>
          </a:prstGeom>
          <a:solidFill>
            <a:schemeClr val="accent1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47" name="テキスト ボックス 46"/>
          <p:cNvSpPr txBox="1"/>
          <p:nvPr/>
        </p:nvSpPr>
        <p:spPr>
          <a:xfrm>
            <a:off x="6449372" y="4615463"/>
            <a:ext cx="456905" cy="30523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*</a:t>
            </a:r>
            <a:endParaRPr lang="ja-JP" altLang="en-US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8" name="直線コネクタ 47"/>
          <p:cNvCxnSpPr/>
          <p:nvPr/>
        </p:nvCxnSpPr>
        <p:spPr bwMode="auto">
          <a:xfrm flipH="1" flipV="1">
            <a:off x="6317629" y="3482835"/>
            <a:ext cx="358044" cy="1135699"/>
          </a:xfrm>
          <a:prstGeom prst="line">
            <a:avLst/>
          </a:prstGeom>
          <a:solidFill>
            <a:schemeClr val="accent1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49" name="直線コネクタ 48"/>
          <p:cNvCxnSpPr/>
          <p:nvPr/>
        </p:nvCxnSpPr>
        <p:spPr bwMode="auto">
          <a:xfrm flipV="1">
            <a:off x="5456324" y="3423821"/>
            <a:ext cx="784493" cy="767977"/>
          </a:xfrm>
          <a:prstGeom prst="line">
            <a:avLst/>
          </a:prstGeom>
          <a:solidFill>
            <a:schemeClr val="accent1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50" name="直線コネクタ 49"/>
          <p:cNvCxnSpPr/>
          <p:nvPr/>
        </p:nvCxnSpPr>
        <p:spPr bwMode="auto">
          <a:xfrm flipV="1">
            <a:off x="5500871" y="3900676"/>
            <a:ext cx="525746" cy="287825"/>
          </a:xfrm>
          <a:prstGeom prst="line">
            <a:avLst/>
          </a:prstGeom>
          <a:solidFill>
            <a:schemeClr val="accent1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</p:spTree>
    <p:extLst>
      <p:ext uri="{BB962C8B-B14F-4D97-AF65-F5344CB8AC3E}">
        <p14:creationId xmlns:p14="http://schemas.microsoft.com/office/powerpoint/2010/main" val="20673380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1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116" t="47369" r="50781" b="26316"/>
          <a:stretch/>
        </p:blipFill>
        <p:spPr bwMode="auto">
          <a:xfrm>
            <a:off x="399371" y="3879366"/>
            <a:ext cx="2520000" cy="252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0" name="Picture 2"/>
          <p:cNvPicPr>
            <a:picLocks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834" t="44522" r="47604" b="19860"/>
          <a:stretch/>
        </p:blipFill>
        <p:spPr bwMode="auto">
          <a:xfrm>
            <a:off x="457379" y="795079"/>
            <a:ext cx="2520000" cy="252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64119" y="16211"/>
            <a:ext cx="3270710" cy="711532"/>
          </a:xfrm>
        </p:spPr>
        <p:txBody>
          <a:bodyPr>
            <a:noAutofit/>
          </a:bodyPr>
          <a:lstStyle/>
          <a:p>
            <a:r>
              <a:rPr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kumimoji="1" lang="en-US" altLang="ja-JP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kumimoji="1" lang="en-US" altLang="ja-JP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0" name="グループ化 69"/>
          <p:cNvGrpSpPr/>
          <p:nvPr/>
        </p:nvGrpSpPr>
        <p:grpSpPr>
          <a:xfrm>
            <a:off x="358798" y="1445072"/>
            <a:ext cx="2709236" cy="2257653"/>
            <a:chOff x="720114" y="1829918"/>
            <a:chExt cx="2709236" cy="2257653"/>
          </a:xfrm>
        </p:grpSpPr>
        <p:grpSp>
          <p:nvGrpSpPr>
            <p:cNvPr id="4" name="グループ化 3"/>
            <p:cNvGrpSpPr/>
            <p:nvPr/>
          </p:nvGrpSpPr>
          <p:grpSpPr>
            <a:xfrm>
              <a:off x="1038038" y="1829918"/>
              <a:ext cx="2301483" cy="1836479"/>
              <a:chOff x="918067" y="2998663"/>
              <a:chExt cx="3068979" cy="2448908"/>
            </a:xfrm>
          </p:grpSpPr>
          <p:sp>
            <p:nvSpPr>
              <p:cNvPr id="6" name="テキスト ボックス 5"/>
              <p:cNvSpPr txBox="1"/>
              <p:nvPr/>
            </p:nvSpPr>
            <p:spPr>
              <a:xfrm>
                <a:off x="2614018" y="2998663"/>
                <a:ext cx="421709" cy="4924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ja-JP" altLang="en-US" dirty="0">
                    <a:solidFill>
                      <a:schemeClr val="bg1"/>
                    </a:solidFill>
                  </a:rPr>
                  <a:t>＊</a:t>
                </a:r>
              </a:p>
            </p:txBody>
          </p:sp>
          <p:sp>
            <p:nvSpPr>
              <p:cNvPr id="7" name="テキスト ボックス 6"/>
              <p:cNvSpPr txBox="1"/>
              <p:nvPr/>
            </p:nvSpPr>
            <p:spPr>
              <a:xfrm>
                <a:off x="2021347" y="3477840"/>
                <a:ext cx="421707" cy="4924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ja-JP" altLang="en-US" dirty="0">
                    <a:solidFill>
                      <a:schemeClr val="bg1"/>
                    </a:solidFill>
                  </a:rPr>
                  <a:t>＊</a:t>
                </a:r>
              </a:p>
            </p:txBody>
          </p:sp>
          <p:sp>
            <p:nvSpPr>
              <p:cNvPr id="8" name="テキスト ボックス 7"/>
              <p:cNvSpPr txBox="1"/>
              <p:nvPr/>
            </p:nvSpPr>
            <p:spPr>
              <a:xfrm>
                <a:off x="1727379" y="3514984"/>
                <a:ext cx="288031" cy="4924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ja-JP" altLang="en-US" dirty="0">
                    <a:solidFill>
                      <a:schemeClr val="bg1"/>
                    </a:solidFill>
                  </a:rPr>
                  <a:t>＊</a:t>
                </a:r>
              </a:p>
            </p:txBody>
          </p:sp>
          <p:cxnSp>
            <p:nvCxnSpPr>
              <p:cNvPr id="9" name="直線コネクタ 8"/>
              <p:cNvCxnSpPr/>
              <p:nvPr/>
            </p:nvCxnSpPr>
            <p:spPr bwMode="auto">
              <a:xfrm>
                <a:off x="2946802" y="3282144"/>
                <a:ext cx="554319" cy="230213"/>
              </a:xfrm>
              <a:prstGeom prst="line">
                <a:avLst/>
              </a:prstGeom>
              <a:solidFill>
                <a:schemeClr val="accent1"/>
              </a:solidFill>
              <a:ln w="190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10" name="テキスト ボックス 9"/>
              <p:cNvSpPr txBox="1"/>
              <p:nvPr/>
            </p:nvSpPr>
            <p:spPr>
              <a:xfrm>
                <a:off x="3420588" y="3298967"/>
                <a:ext cx="566458" cy="44772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US" altLang="ja-JP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</a:t>
                </a:r>
                <a:endParaRPr lang="ja-JP" altLang="en-US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1" name="直線コネクタ 10"/>
              <p:cNvCxnSpPr/>
              <p:nvPr/>
            </p:nvCxnSpPr>
            <p:spPr bwMode="auto">
              <a:xfrm>
                <a:off x="2298380" y="3815955"/>
                <a:ext cx="413570" cy="1290077"/>
              </a:xfrm>
              <a:prstGeom prst="line">
                <a:avLst/>
              </a:prstGeom>
              <a:solidFill>
                <a:schemeClr val="accent1"/>
              </a:solidFill>
              <a:ln w="190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12" name="テキスト ボックス 11"/>
              <p:cNvSpPr txBox="1"/>
              <p:nvPr/>
            </p:nvSpPr>
            <p:spPr>
              <a:xfrm>
                <a:off x="2536022" y="5040549"/>
                <a:ext cx="603147" cy="4070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US" altLang="ja-JP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</a:t>
                </a:r>
                <a:endParaRPr lang="ja-JP" altLang="en-US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3" name="直線コネクタ 12"/>
              <p:cNvCxnSpPr/>
              <p:nvPr/>
            </p:nvCxnSpPr>
            <p:spPr bwMode="auto">
              <a:xfrm>
                <a:off x="1471500" y="3608160"/>
                <a:ext cx="460396" cy="153681"/>
              </a:xfrm>
              <a:prstGeom prst="line">
                <a:avLst/>
              </a:prstGeom>
              <a:solidFill>
                <a:schemeClr val="accent1"/>
              </a:solidFill>
              <a:ln w="190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14" name="テキスト ボックス 13"/>
              <p:cNvSpPr txBox="1"/>
              <p:nvPr/>
            </p:nvSpPr>
            <p:spPr>
              <a:xfrm>
                <a:off x="918067" y="3276477"/>
                <a:ext cx="670200" cy="44772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US" altLang="ja-JP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  <a:endParaRPr lang="ja-JP" altLang="en-US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69" name="テキスト ボックス 68"/>
            <p:cNvSpPr txBox="1"/>
            <p:nvPr/>
          </p:nvSpPr>
          <p:spPr>
            <a:xfrm>
              <a:off x="720114" y="3718239"/>
              <a:ext cx="27092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lang="en-US" altLang="ja-JP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A</a:t>
              </a:r>
              <a:r>
                <a:rPr lang="en-US" altLang="ja-JP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A</a:t>
              </a:r>
              <a:r>
                <a:rPr lang="en-US" altLang="ja-JP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type; 68.1%</a:t>
              </a:r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5" name="グループ化 84"/>
          <p:cNvGrpSpPr/>
          <p:nvPr/>
        </p:nvGrpSpPr>
        <p:grpSpPr>
          <a:xfrm>
            <a:off x="3302885" y="791888"/>
            <a:ext cx="2709236" cy="2906651"/>
            <a:chOff x="3483365" y="791888"/>
            <a:chExt cx="2709236" cy="2906651"/>
          </a:xfrm>
        </p:grpSpPr>
        <p:grpSp>
          <p:nvGrpSpPr>
            <p:cNvPr id="15" name="グループ化 14"/>
            <p:cNvGrpSpPr>
              <a:grpSpLocks/>
            </p:cNvGrpSpPr>
            <p:nvPr/>
          </p:nvGrpSpPr>
          <p:grpSpPr>
            <a:xfrm>
              <a:off x="3555309" y="791888"/>
              <a:ext cx="2520000" cy="2520000"/>
              <a:chOff x="2801858" y="1610077"/>
              <a:chExt cx="3535078" cy="3719504"/>
            </a:xfrm>
          </p:grpSpPr>
          <p:pic>
            <p:nvPicPr>
              <p:cNvPr id="16" name="Picture 3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1249" t="41926" r="40452" b="23065"/>
              <a:stretch/>
            </p:blipFill>
            <p:spPr>
              <a:xfrm>
                <a:off x="2801858" y="1610077"/>
                <a:ext cx="3535078" cy="3719504"/>
              </a:xfrm>
              <a:prstGeom prst="rect">
                <a:avLst/>
              </a:prstGeom>
            </p:spPr>
          </p:pic>
          <p:sp>
            <p:nvSpPr>
              <p:cNvPr id="17" name="テキスト ボックス 16"/>
              <p:cNvSpPr txBox="1"/>
              <p:nvPr/>
            </p:nvSpPr>
            <p:spPr>
              <a:xfrm>
                <a:off x="5062873" y="3038598"/>
                <a:ext cx="488635" cy="5451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ja-JP" altLang="en-US" dirty="0">
                    <a:solidFill>
                      <a:schemeClr val="bg1"/>
                    </a:solidFill>
                  </a:rPr>
                  <a:t>＊</a:t>
                </a:r>
              </a:p>
            </p:txBody>
          </p:sp>
          <p:sp>
            <p:nvSpPr>
              <p:cNvPr id="18" name="テキスト ボックス 17"/>
              <p:cNvSpPr txBox="1"/>
              <p:nvPr/>
            </p:nvSpPr>
            <p:spPr>
              <a:xfrm>
                <a:off x="4801740" y="3220368"/>
                <a:ext cx="487065" cy="5451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ja-JP" altLang="en-US" dirty="0">
                    <a:solidFill>
                      <a:schemeClr val="bg1"/>
                    </a:solidFill>
                  </a:rPr>
                  <a:t>＊</a:t>
                </a:r>
              </a:p>
            </p:txBody>
          </p:sp>
          <p:sp>
            <p:nvSpPr>
              <p:cNvPr id="19" name="テキスト ボックス 18"/>
              <p:cNvSpPr txBox="1"/>
              <p:nvPr/>
            </p:nvSpPr>
            <p:spPr>
              <a:xfrm>
                <a:off x="3873291" y="2727968"/>
                <a:ext cx="452237" cy="5451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ja-JP" altLang="en-US" dirty="0">
                    <a:solidFill>
                      <a:schemeClr val="bg1"/>
                    </a:solidFill>
                  </a:rPr>
                  <a:t>＊</a:t>
                </a:r>
              </a:p>
            </p:txBody>
          </p:sp>
          <p:cxnSp>
            <p:nvCxnSpPr>
              <p:cNvPr id="20" name="直線コネクタ 19"/>
              <p:cNvCxnSpPr/>
              <p:nvPr/>
            </p:nvCxnSpPr>
            <p:spPr bwMode="auto">
              <a:xfrm flipV="1">
                <a:off x="5400107" y="2870055"/>
                <a:ext cx="268868" cy="366876"/>
              </a:xfrm>
              <a:prstGeom prst="line">
                <a:avLst/>
              </a:prstGeom>
              <a:solidFill>
                <a:schemeClr val="accent1"/>
              </a:solidFill>
              <a:ln w="190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21" name="テキスト ボックス 20"/>
              <p:cNvSpPr txBox="1"/>
              <p:nvPr/>
            </p:nvSpPr>
            <p:spPr>
              <a:xfrm>
                <a:off x="5513793" y="2369517"/>
                <a:ext cx="719646" cy="5451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US" altLang="ja-JP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</a:t>
                </a:r>
                <a:endParaRPr lang="ja-JP" altLang="en-US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2" name="直線コネクタ 21"/>
              <p:cNvCxnSpPr/>
              <p:nvPr/>
            </p:nvCxnSpPr>
            <p:spPr bwMode="auto">
              <a:xfrm>
                <a:off x="5107095" y="3567098"/>
                <a:ext cx="561880" cy="857450"/>
              </a:xfrm>
              <a:prstGeom prst="line">
                <a:avLst/>
              </a:prstGeom>
              <a:solidFill>
                <a:schemeClr val="accent1"/>
              </a:solidFill>
              <a:ln w="190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23" name="テキスト ボックス 22"/>
              <p:cNvSpPr txBox="1"/>
              <p:nvPr/>
            </p:nvSpPr>
            <p:spPr>
              <a:xfrm>
                <a:off x="5500298" y="4336597"/>
                <a:ext cx="686988" cy="5451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US" altLang="ja-JP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</a:t>
                </a:r>
                <a:endParaRPr lang="ja-JP" altLang="en-US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4" name="直線コネクタ 23"/>
              <p:cNvCxnSpPr/>
              <p:nvPr/>
            </p:nvCxnSpPr>
            <p:spPr bwMode="auto">
              <a:xfrm>
                <a:off x="4178544" y="3103012"/>
                <a:ext cx="90036" cy="1457408"/>
              </a:xfrm>
              <a:prstGeom prst="line">
                <a:avLst/>
              </a:prstGeom>
              <a:solidFill>
                <a:schemeClr val="accent1"/>
              </a:solidFill>
              <a:ln w="190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25" name="テキスト ボックス 24"/>
              <p:cNvSpPr txBox="1"/>
              <p:nvPr/>
            </p:nvSpPr>
            <p:spPr>
              <a:xfrm>
                <a:off x="3941636" y="4459434"/>
                <a:ext cx="780802" cy="5451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US" altLang="ja-JP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  <a:endParaRPr lang="ja-JP" altLang="en-US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74" name="テキスト ボックス 73"/>
            <p:cNvSpPr txBox="1"/>
            <p:nvPr/>
          </p:nvSpPr>
          <p:spPr>
            <a:xfrm>
              <a:off x="3483365" y="3329207"/>
              <a:ext cx="27092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lang="en-US" altLang="ja-JP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A</a:t>
              </a:r>
              <a:r>
                <a:rPr lang="en-US" altLang="ja-JP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A</a:t>
              </a:r>
              <a:r>
                <a:rPr lang="en-US" altLang="ja-JP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type; 11.1%</a:t>
              </a:r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6" name="グループ化 85"/>
          <p:cNvGrpSpPr/>
          <p:nvPr/>
        </p:nvGrpSpPr>
        <p:grpSpPr>
          <a:xfrm>
            <a:off x="6040822" y="795079"/>
            <a:ext cx="3107538" cy="2911476"/>
            <a:chOff x="6125046" y="795079"/>
            <a:chExt cx="3107538" cy="2911476"/>
          </a:xfrm>
        </p:grpSpPr>
        <p:grpSp>
          <p:nvGrpSpPr>
            <p:cNvPr id="26" name="グループ化 25"/>
            <p:cNvGrpSpPr/>
            <p:nvPr/>
          </p:nvGrpSpPr>
          <p:grpSpPr>
            <a:xfrm>
              <a:off x="6332808" y="795079"/>
              <a:ext cx="2684068" cy="2520000"/>
              <a:chOff x="5521901" y="2082206"/>
              <a:chExt cx="3578744" cy="3360000"/>
            </a:xfrm>
          </p:grpSpPr>
          <p:pic>
            <p:nvPicPr>
              <p:cNvPr id="27" name="Picture 3"/>
              <p:cNvPicPr>
                <a:picLocks noChangeArrowheads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803" t="44848" r="34692" b="26744"/>
              <a:stretch/>
            </p:blipFill>
            <p:spPr>
              <a:xfrm>
                <a:off x="5740655" y="2082206"/>
                <a:ext cx="3359990" cy="3360000"/>
              </a:xfrm>
              <a:prstGeom prst="rect">
                <a:avLst/>
              </a:prstGeom>
            </p:spPr>
          </p:pic>
          <p:sp>
            <p:nvSpPr>
              <p:cNvPr id="28" name="テキスト ボックス 27"/>
              <p:cNvSpPr txBox="1"/>
              <p:nvPr/>
            </p:nvSpPr>
            <p:spPr>
              <a:xfrm>
                <a:off x="7417934" y="2206575"/>
                <a:ext cx="288032" cy="4924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ja-JP" altLang="en-US" dirty="0">
                    <a:solidFill>
                      <a:schemeClr val="bg1"/>
                    </a:solidFill>
                  </a:rPr>
                  <a:t>＊</a:t>
                </a:r>
              </a:p>
            </p:txBody>
          </p:sp>
          <p:sp>
            <p:nvSpPr>
              <p:cNvPr id="29" name="テキスト ボックス 28"/>
              <p:cNvSpPr txBox="1"/>
              <p:nvPr/>
            </p:nvSpPr>
            <p:spPr>
              <a:xfrm>
                <a:off x="7443753" y="2467415"/>
                <a:ext cx="288032" cy="4924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ja-JP" altLang="en-US" dirty="0">
                    <a:solidFill>
                      <a:schemeClr val="bg1"/>
                    </a:solidFill>
                  </a:rPr>
                  <a:t>＊</a:t>
                </a:r>
              </a:p>
            </p:txBody>
          </p:sp>
          <p:sp>
            <p:nvSpPr>
              <p:cNvPr id="30" name="テキスト ボックス 29"/>
              <p:cNvSpPr txBox="1"/>
              <p:nvPr/>
            </p:nvSpPr>
            <p:spPr>
              <a:xfrm>
                <a:off x="7062778" y="2889965"/>
                <a:ext cx="288032" cy="4924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ja-JP" altLang="en-US" dirty="0">
                    <a:solidFill>
                      <a:schemeClr val="bg1"/>
                    </a:solidFill>
                  </a:rPr>
                  <a:t>＊</a:t>
                </a:r>
              </a:p>
            </p:txBody>
          </p:sp>
          <p:sp>
            <p:nvSpPr>
              <p:cNvPr id="31" name="テキスト ボックス 30"/>
              <p:cNvSpPr txBox="1"/>
              <p:nvPr/>
            </p:nvSpPr>
            <p:spPr>
              <a:xfrm>
                <a:off x="6660515" y="3001895"/>
                <a:ext cx="288032" cy="4924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ja-JP" altLang="en-US" dirty="0">
                    <a:solidFill>
                      <a:schemeClr val="bg1"/>
                    </a:solidFill>
                  </a:rPr>
                  <a:t>＊</a:t>
                </a:r>
              </a:p>
            </p:txBody>
          </p:sp>
          <p:cxnSp>
            <p:nvCxnSpPr>
              <p:cNvPr id="32" name="直線コネクタ 31"/>
              <p:cNvCxnSpPr/>
              <p:nvPr/>
            </p:nvCxnSpPr>
            <p:spPr bwMode="auto">
              <a:xfrm>
                <a:off x="7757062" y="2460086"/>
                <a:ext cx="490945" cy="31937"/>
              </a:xfrm>
              <a:prstGeom prst="line">
                <a:avLst/>
              </a:prstGeom>
              <a:solidFill>
                <a:schemeClr val="accent1"/>
              </a:solidFill>
              <a:ln w="190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33" name="テキスト ボックス 32"/>
              <p:cNvSpPr txBox="1"/>
              <p:nvPr/>
            </p:nvSpPr>
            <p:spPr>
              <a:xfrm>
                <a:off x="8172396" y="2223954"/>
                <a:ext cx="919577" cy="4924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US" altLang="ja-JP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</a:t>
                </a:r>
                <a:endParaRPr lang="ja-JP" altLang="en-US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4" name="直線コネクタ 33"/>
              <p:cNvCxnSpPr/>
              <p:nvPr/>
            </p:nvCxnSpPr>
            <p:spPr bwMode="auto">
              <a:xfrm>
                <a:off x="7739847" y="2837818"/>
                <a:ext cx="616425" cy="1878028"/>
              </a:xfrm>
              <a:prstGeom prst="line">
                <a:avLst/>
              </a:prstGeom>
              <a:solidFill>
                <a:schemeClr val="accent1"/>
              </a:solidFill>
              <a:ln w="190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35" name="テキスト ボックス 34"/>
              <p:cNvSpPr txBox="1"/>
              <p:nvPr/>
            </p:nvSpPr>
            <p:spPr>
              <a:xfrm>
                <a:off x="8160874" y="4651218"/>
                <a:ext cx="733225" cy="4924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US" altLang="ja-JP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</a:t>
                </a:r>
                <a:endParaRPr lang="ja-JP" altLang="en-US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6" name="直線コネクタ 35"/>
              <p:cNvCxnSpPr/>
              <p:nvPr/>
            </p:nvCxnSpPr>
            <p:spPr bwMode="auto">
              <a:xfrm flipV="1">
                <a:off x="7128232" y="3214570"/>
                <a:ext cx="201682" cy="1501276"/>
              </a:xfrm>
              <a:prstGeom prst="line">
                <a:avLst/>
              </a:prstGeom>
              <a:solidFill>
                <a:schemeClr val="accent1"/>
              </a:solidFill>
              <a:ln w="190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37" name="テキスト ボックス 36"/>
              <p:cNvSpPr txBox="1"/>
              <p:nvPr/>
            </p:nvSpPr>
            <p:spPr>
              <a:xfrm>
                <a:off x="6880132" y="4647349"/>
                <a:ext cx="605196" cy="4476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US" altLang="ja-JP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</a:t>
                </a:r>
                <a:endParaRPr lang="ja-JP" altLang="en-US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8" name="直線コネクタ 37"/>
              <p:cNvCxnSpPr/>
              <p:nvPr/>
            </p:nvCxnSpPr>
            <p:spPr bwMode="auto">
              <a:xfrm flipV="1">
                <a:off x="6074891" y="3292454"/>
                <a:ext cx="797491" cy="1343300"/>
              </a:xfrm>
              <a:prstGeom prst="line">
                <a:avLst/>
              </a:prstGeom>
              <a:solidFill>
                <a:schemeClr val="accent1"/>
              </a:solidFill>
              <a:ln w="190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39" name="テキスト ボックス 38"/>
              <p:cNvSpPr txBox="1"/>
              <p:nvPr/>
            </p:nvSpPr>
            <p:spPr>
              <a:xfrm>
                <a:off x="5521901" y="4549443"/>
                <a:ext cx="787138" cy="4924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US" altLang="ja-JP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  <a:endParaRPr lang="ja-JP" altLang="en-US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80" name="テキスト ボックス 79"/>
            <p:cNvSpPr txBox="1"/>
            <p:nvPr/>
          </p:nvSpPr>
          <p:spPr>
            <a:xfrm>
              <a:off x="6909971" y="1332417"/>
              <a:ext cx="32238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dirty="0">
                  <a:solidFill>
                    <a:schemeClr val="bg1"/>
                  </a:solidFill>
                </a:rPr>
                <a:t>＊</a:t>
              </a:r>
            </a:p>
          </p:txBody>
        </p:sp>
        <p:sp>
          <p:nvSpPr>
            <p:cNvPr id="81" name="テキスト ボックス 80"/>
            <p:cNvSpPr txBox="1"/>
            <p:nvPr/>
          </p:nvSpPr>
          <p:spPr>
            <a:xfrm>
              <a:off x="6460838" y="1334542"/>
              <a:ext cx="4282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lang="en-US" altLang="ja-JP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lang="ja-JP" alt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2" name="直線コネクタ 81"/>
            <p:cNvCxnSpPr/>
            <p:nvPr/>
          </p:nvCxnSpPr>
          <p:spPr bwMode="auto">
            <a:xfrm flipV="1">
              <a:off x="6805073" y="1527502"/>
              <a:ext cx="257991" cy="10555"/>
            </a:xfrm>
            <a:prstGeom prst="line">
              <a:avLst/>
            </a:prstGeom>
            <a:solidFill>
              <a:schemeClr val="accent1"/>
            </a:solidFill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84" name="テキスト ボックス 83"/>
            <p:cNvSpPr txBox="1"/>
            <p:nvPr/>
          </p:nvSpPr>
          <p:spPr>
            <a:xfrm>
              <a:off x="6125046" y="3337223"/>
              <a:ext cx="3107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lang="en-US" altLang="ja-JP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A</a:t>
              </a:r>
              <a:r>
                <a:rPr lang="en-US" altLang="ja-JP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A</a:t>
              </a:r>
              <a:r>
                <a:rPr lang="en-US" altLang="ja-JP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A</a:t>
              </a:r>
              <a:r>
                <a:rPr lang="en-US" altLang="ja-JP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type; 14.1%</a:t>
              </a:r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87" name="テキスト ボックス 86"/>
          <p:cNvSpPr txBox="1"/>
          <p:nvPr/>
        </p:nvSpPr>
        <p:spPr>
          <a:xfrm>
            <a:off x="26905" y="611714"/>
            <a:ext cx="37596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3200" dirty="0"/>
          </a:p>
        </p:txBody>
      </p:sp>
      <p:sp>
        <p:nvSpPr>
          <p:cNvPr id="88" name="テキスト ボックス 87"/>
          <p:cNvSpPr txBox="1"/>
          <p:nvPr/>
        </p:nvSpPr>
        <p:spPr>
          <a:xfrm>
            <a:off x="2994700" y="631762"/>
            <a:ext cx="37596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3200" dirty="0"/>
          </a:p>
        </p:txBody>
      </p:sp>
      <p:sp>
        <p:nvSpPr>
          <p:cNvPr id="89" name="テキスト ボックス 88"/>
          <p:cNvSpPr txBox="1"/>
          <p:nvPr/>
        </p:nvSpPr>
        <p:spPr>
          <a:xfrm>
            <a:off x="5954472" y="619730"/>
            <a:ext cx="37596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3200" dirty="0"/>
          </a:p>
        </p:txBody>
      </p:sp>
      <p:grpSp>
        <p:nvGrpSpPr>
          <p:cNvPr id="95" name="グループ化 94"/>
          <p:cNvGrpSpPr/>
          <p:nvPr/>
        </p:nvGrpSpPr>
        <p:grpSpPr>
          <a:xfrm>
            <a:off x="3374829" y="3879151"/>
            <a:ext cx="2897128" cy="2886184"/>
            <a:chOff x="1121158" y="3876398"/>
            <a:chExt cx="2897128" cy="2886184"/>
          </a:xfrm>
        </p:grpSpPr>
        <p:grpSp>
          <p:nvGrpSpPr>
            <p:cNvPr id="40" name="グループ化 39"/>
            <p:cNvGrpSpPr/>
            <p:nvPr/>
          </p:nvGrpSpPr>
          <p:grpSpPr>
            <a:xfrm>
              <a:off x="1351693" y="3876398"/>
              <a:ext cx="2596300" cy="2526319"/>
              <a:chOff x="1907704" y="4878089"/>
              <a:chExt cx="3634749" cy="3220095"/>
            </a:xfrm>
          </p:grpSpPr>
          <p:pic>
            <p:nvPicPr>
              <p:cNvPr id="41" name="Picture 3"/>
              <p:cNvPicPr>
                <a:picLocks noChangeArrowheads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1251" t="59118" r="37974" b="12744"/>
              <a:stretch/>
            </p:blipFill>
            <p:spPr>
              <a:xfrm>
                <a:off x="1907704" y="4886144"/>
                <a:ext cx="3527931" cy="3212040"/>
              </a:xfrm>
              <a:prstGeom prst="rect">
                <a:avLst/>
              </a:prstGeom>
            </p:spPr>
          </p:pic>
          <p:sp>
            <p:nvSpPr>
              <p:cNvPr id="42" name="テキスト ボックス 41"/>
              <p:cNvSpPr txBox="1"/>
              <p:nvPr/>
            </p:nvSpPr>
            <p:spPr>
              <a:xfrm>
                <a:off x="3886873" y="5645215"/>
                <a:ext cx="288032" cy="4707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ja-JP" altLang="en-US" dirty="0">
                    <a:solidFill>
                      <a:schemeClr val="bg1"/>
                    </a:solidFill>
                  </a:rPr>
                  <a:t>＊</a:t>
                </a:r>
              </a:p>
            </p:txBody>
          </p:sp>
          <p:sp>
            <p:nvSpPr>
              <p:cNvPr id="43" name="テキスト ボックス 42"/>
              <p:cNvSpPr txBox="1"/>
              <p:nvPr/>
            </p:nvSpPr>
            <p:spPr>
              <a:xfrm>
                <a:off x="3368335" y="5490883"/>
                <a:ext cx="413019" cy="4707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ja-JP" altLang="en-US" dirty="0">
                    <a:solidFill>
                      <a:schemeClr val="bg1"/>
                    </a:solidFill>
                  </a:rPr>
                  <a:t>＊</a:t>
                </a:r>
              </a:p>
            </p:txBody>
          </p:sp>
          <p:sp>
            <p:nvSpPr>
              <p:cNvPr id="44" name="テキスト ボックス 43"/>
              <p:cNvSpPr txBox="1"/>
              <p:nvPr/>
            </p:nvSpPr>
            <p:spPr>
              <a:xfrm>
                <a:off x="2868607" y="5435748"/>
                <a:ext cx="454595" cy="4707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ja-JP" altLang="en-US" dirty="0">
                    <a:solidFill>
                      <a:schemeClr val="bg1"/>
                    </a:solidFill>
                  </a:rPr>
                  <a:t>＊</a:t>
                </a:r>
              </a:p>
            </p:txBody>
          </p:sp>
          <p:cxnSp>
            <p:nvCxnSpPr>
              <p:cNvPr id="45" name="直線コネクタ 44"/>
              <p:cNvCxnSpPr/>
              <p:nvPr/>
            </p:nvCxnSpPr>
            <p:spPr bwMode="auto">
              <a:xfrm>
                <a:off x="4253304" y="5905974"/>
                <a:ext cx="633215" cy="249228"/>
              </a:xfrm>
              <a:prstGeom prst="line">
                <a:avLst/>
              </a:prstGeom>
              <a:solidFill>
                <a:schemeClr val="accent1"/>
              </a:solidFill>
              <a:ln w="190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46" name="テキスト ボックス 45"/>
              <p:cNvSpPr txBox="1"/>
              <p:nvPr/>
            </p:nvSpPr>
            <p:spPr>
              <a:xfrm>
                <a:off x="4789665" y="5944175"/>
                <a:ext cx="752788" cy="4707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US" altLang="ja-JP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</a:t>
                </a:r>
                <a:endParaRPr lang="ja-JP" altLang="en-US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7" name="直線コネクタ 46"/>
              <p:cNvCxnSpPr/>
              <p:nvPr/>
            </p:nvCxnSpPr>
            <p:spPr bwMode="auto">
              <a:xfrm>
                <a:off x="3677093" y="5796211"/>
                <a:ext cx="572650" cy="1294920"/>
              </a:xfrm>
              <a:prstGeom prst="line">
                <a:avLst/>
              </a:prstGeom>
              <a:solidFill>
                <a:schemeClr val="accent1"/>
              </a:solidFill>
              <a:ln w="190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48" name="テキスト ボックス 47"/>
              <p:cNvSpPr txBox="1"/>
              <p:nvPr/>
            </p:nvSpPr>
            <p:spPr>
              <a:xfrm>
                <a:off x="4010008" y="7007821"/>
                <a:ext cx="656811" cy="3890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US" altLang="ja-JP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</a:t>
                </a:r>
                <a:endParaRPr lang="ja-JP" altLang="en-US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9" name="直線コネクタ 48"/>
              <p:cNvCxnSpPr/>
              <p:nvPr/>
            </p:nvCxnSpPr>
            <p:spPr bwMode="auto">
              <a:xfrm>
                <a:off x="2729111" y="5296180"/>
                <a:ext cx="355464" cy="328406"/>
              </a:xfrm>
              <a:prstGeom prst="line">
                <a:avLst/>
              </a:prstGeom>
              <a:solidFill>
                <a:schemeClr val="accent1"/>
              </a:solidFill>
              <a:ln w="190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50" name="テキスト ボックス 49"/>
              <p:cNvSpPr txBox="1"/>
              <p:nvPr/>
            </p:nvSpPr>
            <p:spPr>
              <a:xfrm>
                <a:off x="2341200" y="4878089"/>
                <a:ext cx="775392" cy="4707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US" altLang="ja-JP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  <a:endParaRPr lang="ja-JP" altLang="en-US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93" name="テキスト ボックス 92"/>
            <p:cNvSpPr txBox="1"/>
            <p:nvPr/>
          </p:nvSpPr>
          <p:spPr>
            <a:xfrm>
              <a:off x="1121158" y="6393250"/>
              <a:ext cx="28971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lang="en-US" altLang="ja-JP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A</a:t>
              </a:r>
              <a:r>
                <a:rPr lang="en-US" altLang="ja-JP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A</a:t>
              </a:r>
              <a:r>
                <a:rPr lang="en-US" altLang="ja-JP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type; 4.1%</a:t>
              </a:r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94" name="テキスト ボックス 93"/>
          <p:cNvSpPr txBox="1"/>
          <p:nvPr/>
        </p:nvSpPr>
        <p:spPr>
          <a:xfrm>
            <a:off x="18878" y="3683773"/>
            <a:ext cx="37596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kumimoji="1" lang="ja-JP" altLang="en-US" sz="3200" dirty="0"/>
          </a:p>
        </p:txBody>
      </p:sp>
      <p:grpSp>
        <p:nvGrpSpPr>
          <p:cNvPr id="108" name="グループ化 107"/>
          <p:cNvGrpSpPr/>
          <p:nvPr/>
        </p:nvGrpSpPr>
        <p:grpSpPr>
          <a:xfrm>
            <a:off x="162102" y="4381329"/>
            <a:ext cx="3057817" cy="2370491"/>
            <a:chOff x="3078284" y="4412143"/>
            <a:chExt cx="3057817" cy="2370491"/>
          </a:xfrm>
        </p:grpSpPr>
        <p:grpSp>
          <p:nvGrpSpPr>
            <p:cNvPr id="51" name="グループ化 50"/>
            <p:cNvGrpSpPr/>
            <p:nvPr/>
          </p:nvGrpSpPr>
          <p:grpSpPr>
            <a:xfrm>
              <a:off x="4123996" y="4629097"/>
              <a:ext cx="1577743" cy="1677575"/>
              <a:chOff x="4789380" y="4426345"/>
              <a:chExt cx="2103646" cy="2236768"/>
            </a:xfrm>
          </p:grpSpPr>
          <p:sp>
            <p:nvSpPr>
              <p:cNvPr id="53" name="テキスト ボックス 52"/>
              <p:cNvSpPr txBox="1"/>
              <p:nvPr/>
            </p:nvSpPr>
            <p:spPr>
              <a:xfrm>
                <a:off x="5594906" y="4706284"/>
                <a:ext cx="553173" cy="4924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ja-JP" altLang="en-US" dirty="0">
                    <a:solidFill>
                      <a:schemeClr val="bg1"/>
                    </a:solidFill>
                  </a:rPr>
                  <a:t>＊</a:t>
                </a:r>
              </a:p>
            </p:txBody>
          </p:sp>
          <p:sp>
            <p:nvSpPr>
              <p:cNvPr id="55" name="テキスト ボックス 54"/>
              <p:cNvSpPr txBox="1"/>
              <p:nvPr/>
            </p:nvSpPr>
            <p:spPr>
              <a:xfrm>
                <a:off x="5070830" y="4547212"/>
                <a:ext cx="463879" cy="4924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ja-JP" altLang="en-US" dirty="0">
                    <a:solidFill>
                      <a:schemeClr val="bg1"/>
                    </a:solidFill>
                  </a:rPr>
                  <a:t>＊</a:t>
                </a:r>
              </a:p>
            </p:txBody>
          </p:sp>
          <p:sp>
            <p:nvSpPr>
              <p:cNvPr id="57" name="テキスト ボックス 56"/>
              <p:cNvSpPr txBox="1"/>
              <p:nvPr/>
            </p:nvSpPr>
            <p:spPr>
              <a:xfrm>
                <a:off x="5364088" y="5805266"/>
                <a:ext cx="288032" cy="5334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ja-JP" altLang="en-US" sz="2000" dirty="0">
                    <a:solidFill>
                      <a:schemeClr val="bg1"/>
                    </a:solidFill>
                  </a:rPr>
                  <a:t>＊</a:t>
                </a:r>
              </a:p>
            </p:txBody>
          </p:sp>
          <p:cxnSp>
            <p:nvCxnSpPr>
              <p:cNvPr id="58" name="直線コネクタ 57"/>
              <p:cNvCxnSpPr/>
              <p:nvPr/>
            </p:nvCxnSpPr>
            <p:spPr bwMode="auto">
              <a:xfrm>
                <a:off x="5956439" y="4963569"/>
                <a:ext cx="419019" cy="112857"/>
              </a:xfrm>
              <a:prstGeom prst="line">
                <a:avLst/>
              </a:prstGeom>
              <a:solidFill>
                <a:schemeClr val="accent1"/>
              </a:solidFill>
              <a:ln w="190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59" name="テキスト ボックス 58"/>
              <p:cNvSpPr txBox="1"/>
              <p:nvPr/>
            </p:nvSpPr>
            <p:spPr>
              <a:xfrm>
                <a:off x="6283177" y="4861291"/>
                <a:ext cx="609849" cy="4069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US" altLang="ja-JP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</a:t>
                </a:r>
                <a:endParaRPr lang="ja-JP" altLang="en-US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64" name="直線コネクタ 63"/>
              <p:cNvCxnSpPr/>
              <p:nvPr/>
            </p:nvCxnSpPr>
            <p:spPr bwMode="auto">
              <a:xfrm>
                <a:off x="5359824" y="4895339"/>
                <a:ext cx="383959" cy="1333330"/>
              </a:xfrm>
              <a:prstGeom prst="line">
                <a:avLst/>
              </a:prstGeom>
              <a:solidFill>
                <a:schemeClr val="accent1"/>
              </a:solidFill>
              <a:ln w="190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65" name="テキスト ボックス 64"/>
              <p:cNvSpPr txBox="1"/>
              <p:nvPr/>
            </p:nvSpPr>
            <p:spPr>
              <a:xfrm>
                <a:off x="5501624" y="6170670"/>
                <a:ext cx="712451" cy="4924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US" altLang="ja-JP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</a:t>
                </a:r>
                <a:endParaRPr lang="ja-JP" altLang="en-US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66" name="直線コネクタ 65"/>
              <p:cNvCxnSpPr/>
              <p:nvPr/>
            </p:nvCxnSpPr>
            <p:spPr bwMode="auto">
              <a:xfrm flipH="1" flipV="1">
                <a:off x="4789380" y="4426345"/>
                <a:ext cx="650461" cy="23147"/>
              </a:xfrm>
              <a:prstGeom prst="line">
                <a:avLst/>
              </a:prstGeom>
              <a:solidFill>
                <a:schemeClr val="accent1"/>
              </a:solidFill>
              <a:ln w="190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</p:grpSp>
        <p:sp>
          <p:nvSpPr>
            <p:cNvPr id="102" name="テキスト ボックス 101"/>
            <p:cNvSpPr txBox="1"/>
            <p:nvPr/>
          </p:nvSpPr>
          <p:spPr>
            <a:xfrm>
              <a:off x="4468056" y="4472438"/>
              <a:ext cx="34791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dirty="0">
                  <a:solidFill>
                    <a:schemeClr val="bg1"/>
                  </a:solidFill>
                </a:rPr>
                <a:t>＊</a:t>
              </a:r>
            </a:p>
          </p:txBody>
        </p:sp>
        <p:sp>
          <p:nvSpPr>
            <p:cNvPr id="106" name="テキスト ボックス 105"/>
            <p:cNvSpPr txBox="1"/>
            <p:nvPr/>
          </p:nvSpPr>
          <p:spPr>
            <a:xfrm>
              <a:off x="3321357" y="4412143"/>
              <a:ext cx="908235" cy="3357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lang="en-US" altLang="ja-JP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A</a:t>
              </a:r>
              <a:r>
                <a:rPr lang="en-US" altLang="ja-JP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ja-JP" alt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" name="テキスト ボックス 106"/>
            <p:cNvSpPr txBox="1"/>
            <p:nvPr/>
          </p:nvSpPr>
          <p:spPr>
            <a:xfrm>
              <a:off x="3078284" y="6413302"/>
              <a:ext cx="30578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lang="en-US" altLang="ja-JP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A</a:t>
              </a:r>
              <a:r>
                <a:rPr lang="en-US" altLang="ja-JP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A</a:t>
              </a:r>
              <a:r>
                <a:rPr lang="en-US" altLang="ja-JP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A</a:t>
              </a:r>
              <a:r>
                <a:rPr lang="en-US" altLang="ja-JP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type; 2.6%</a:t>
              </a:r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09" name="テキスト ボックス 108"/>
          <p:cNvSpPr txBox="1"/>
          <p:nvPr/>
        </p:nvSpPr>
        <p:spPr>
          <a:xfrm>
            <a:off x="3058861" y="3679761"/>
            <a:ext cx="37596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kumimoji="1" lang="ja-JP" altLang="en-US" sz="3200" dirty="0"/>
          </a:p>
        </p:txBody>
      </p:sp>
      <p:sp>
        <p:nvSpPr>
          <p:cNvPr id="3" name="テキスト ボックス 2"/>
          <p:cNvSpPr txBox="1"/>
          <p:nvPr/>
        </p:nvSpPr>
        <p:spPr>
          <a:xfrm>
            <a:off x="2454374" y="5274613"/>
            <a:ext cx="468575" cy="11618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0586653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4" name="Picture 2"/>
          <p:cNvPicPr>
            <a:picLocks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778" t="48214" r="47439" b="17857"/>
          <a:stretch/>
        </p:blipFill>
        <p:spPr bwMode="auto">
          <a:xfrm>
            <a:off x="450649" y="3939719"/>
            <a:ext cx="2520000" cy="252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7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605" t="47368" r="35451" b="15790"/>
          <a:stretch/>
        </p:blipFill>
        <p:spPr bwMode="auto">
          <a:xfrm>
            <a:off x="3441948" y="859329"/>
            <a:ext cx="2520000" cy="252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3" name="Picture 2"/>
          <p:cNvPicPr>
            <a:picLocks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954" t="46338" r="41013" b="16236"/>
          <a:stretch/>
        </p:blipFill>
        <p:spPr bwMode="auto">
          <a:xfrm>
            <a:off x="3457384" y="3900909"/>
            <a:ext cx="2520000" cy="252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0" name="Picture 2"/>
          <p:cNvPicPr>
            <a:picLocks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170" t="48214" r="37583" b="12500"/>
          <a:stretch/>
        </p:blipFill>
        <p:spPr bwMode="auto">
          <a:xfrm>
            <a:off x="6423604" y="852244"/>
            <a:ext cx="2520000" cy="252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テキスト ボックス 5"/>
          <p:cNvSpPr txBox="1"/>
          <p:nvPr/>
        </p:nvSpPr>
        <p:spPr>
          <a:xfrm>
            <a:off x="4557493" y="1542543"/>
            <a:ext cx="3255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>
                <a:solidFill>
                  <a:schemeClr val="bg1"/>
                </a:solidFill>
              </a:rPr>
              <a:t>＊</a:t>
            </a: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985998" y="2172451"/>
            <a:ext cx="216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>
                <a:solidFill>
                  <a:schemeClr val="bg1"/>
                </a:solidFill>
              </a:rPr>
              <a:t>＊</a:t>
            </a:r>
          </a:p>
        </p:txBody>
      </p:sp>
      <p:cxnSp>
        <p:nvCxnSpPr>
          <p:cNvPr id="9" name="直線コネクタ 8"/>
          <p:cNvCxnSpPr/>
          <p:nvPr/>
        </p:nvCxnSpPr>
        <p:spPr bwMode="auto">
          <a:xfrm>
            <a:off x="4772300" y="1800724"/>
            <a:ext cx="756952" cy="939346"/>
          </a:xfrm>
          <a:prstGeom prst="line">
            <a:avLst/>
          </a:prstGeom>
          <a:solidFill>
            <a:schemeClr val="accent1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10" name="テキスト ボックス 9"/>
          <p:cNvSpPr txBox="1"/>
          <p:nvPr/>
        </p:nvSpPr>
        <p:spPr>
          <a:xfrm>
            <a:off x="5408868" y="2678740"/>
            <a:ext cx="434278" cy="3052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ja-JP" altLang="en-US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5" name="グループ化 14"/>
          <p:cNvGrpSpPr/>
          <p:nvPr/>
        </p:nvGrpSpPr>
        <p:grpSpPr>
          <a:xfrm>
            <a:off x="429393" y="861569"/>
            <a:ext cx="2541256" cy="2519999"/>
            <a:chOff x="3463526" y="2060848"/>
            <a:chExt cx="3388350" cy="3546765"/>
          </a:xfrm>
        </p:grpSpPr>
        <p:pic>
          <p:nvPicPr>
            <p:cNvPr id="16" name="Picture 3"/>
            <p:cNvPicPr>
              <a:picLocks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250" t="54727" r="40375" b="8680"/>
            <a:stretch/>
          </p:blipFill>
          <p:spPr>
            <a:xfrm>
              <a:off x="3491867" y="2060848"/>
              <a:ext cx="3360009" cy="3546765"/>
            </a:xfrm>
            <a:prstGeom prst="rect">
              <a:avLst/>
            </a:prstGeom>
          </p:spPr>
        </p:pic>
        <p:sp>
          <p:nvSpPr>
            <p:cNvPr id="17" name="テキスト ボックス 16"/>
            <p:cNvSpPr txBox="1"/>
            <p:nvPr/>
          </p:nvSpPr>
          <p:spPr>
            <a:xfrm>
              <a:off x="5042727" y="3194803"/>
              <a:ext cx="288031" cy="5198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dirty="0">
                  <a:solidFill>
                    <a:schemeClr val="bg1"/>
                  </a:solidFill>
                </a:rPr>
                <a:t>＊</a:t>
              </a: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4966212" y="3579675"/>
              <a:ext cx="288031" cy="5198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dirty="0">
                  <a:solidFill>
                    <a:schemeClr val="bg1"/>
                  </a:solidFill>
                </a:rPr>
                <a:t>＊</a:t>
              </a: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4299928" y="3906186"/>
              <a:ext cx="288031" cy="5198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dirty="0">
                  <a:solidFill>
                    <a:schemeClr val="bg1"/>
                  </a:solidFill>
                </a:rPr>
                <a:t>＊</a:t>
              </a:r>
            </a:p>
          </p:txBody>
        </p:sp>
        <p:cxnSp>
          <p:nvCxnSpPr>
            <p:cNvPr id="20" name="直線コネクタ 19"/>
            <p:cNvCxnSpPr/>
            <p:nvPr/>
          </p:nvCxnSpPr>
          <p:spPr bwMode="auto">
            <a:xfrm>
              <a:off x="5337816" y="3530011"/>
              <a:ext cx="747058" cy="1231887"/>
            </a:xfrm>
            <a:prstGeom prst="line">
              <a:avLst/>
            </a:prstGeom>
            <a:solidFill>
              <a:schemeClr val="accent1"/>
            </a:solidFill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21" name="テキスト ボックス 20"/>
            <p:cNvSpPr txBox="1"/>
            <p:nvPr/>
          </p:nvSpPr>
          <p:spPr>
            <a:xfrm>
              <a:off x="5881884" y="4685941"/>
              <a:ext cx="603583" cy="4295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</a:t>
              </a:r>
              <a:r>
                <a:rPr lang="en-US" altLang="ja-JP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lang="ja-JP" alt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2" name="直線コネクタ 21"/>
            <p:cNvCxnSpPr/>
            <p:nvPr/>
          </p:nvCxnSpPr>
          <p:spPr bwMode="auto">
            <a:xfrm flipH="1">
              <a:off x="5223510" y="3907956"/>
              <a:ext cx="13469" cy="1054345"/>
            </a:xfrm>
            <a:prstGeom prst="line">
              <a:avLst/>
            </a:prstGeom>
            <a:solidFill>
              <a:schemeClr val="accent1"/>
            </a:solidFill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23" name="テキスト ボックス 22"/>
            <p:cNvSpPr txBox="1"/>
            <p:nvPr/>
          </p:nvSpPr>
          <p:spPr>
            <a:xfrm>
              <a:off x="4954738" y="4892629"/>
              <a:ext cx="569721" cy="4295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</a:t>
              </a:r>
              <a:r>
                <a:rPr lang="en-US" altLang="ja-JP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lang="ja-JP" alt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4" name="直線コネクタ 23"/>
            <p:cNvCxnSpPr/>
            <p:nvPr/>
          </p:nvCxnSpPr>
          <p:spPr bwMode="auto">
            <a:xfrm flipH="1">
              <a:off x="4008299" y="4219202"/>
              <a:ext cx="468376" cy="542697"/>
            </a:xfrm>
            <a:prstGeom prst="line">
              <a:avLst/>
            </a:prstGeom>
            <a:solidFill>
              <a:schemeClr val="accent1"/>
            </a:solidFill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25" name="テキスト ボックス 24"/>
            <p:cNvSpPr txBox="1"/>
            <p:nvPr/>
          </p:nvSpPr>
          <p:spPr>
            <a:xfrm>
              <a:off x="3463526" y="4704737"/>
              <a:ext cx="906421" cy="5198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</a:t>
              </a:r>
              <a:r>
                <a:rPr lang="en-US" altLang="ja-JP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ja-JP" alt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8" name="テキスト ボックス 27"/>
          <p:cNvSpPr txBox="1"/>
          <p:nvPr/>
        </p:nvSpPr>
        <p:spPr>
          <a:xfrm>
            <a:off x="1790350" y="5158621"/>
            <a:ext cx="3113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>
                <a:solidFill>
                  <a:schemeClr val="bg1"/>
                </a:solidFill>
              </a:rPr>
              <a:t>＊</a:t>
            </a: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1393577" y="4975750"/>
            <a:ext cx="2160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>
                <a:solidFill>
                  <a:schemeClr val="bg1"/>
                </a:solidFill>
              </a:rPr>
              <a:t>＊</a:t>
            </a: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1041517" y="5220633"/>
            <a:ext cx="2160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>
                <a:solidFill>
                  <a:schemeClr val="bg1"/>
                </a:solidFill>
              </a:rPr>
              <a:t>＊</a:t>
            </a:r>
          </a:p>
        </p:txBody>
      </p:sp>
      <p:cxnSp>
        <p:nvCxnSpPr>
          <p:cNvPr id="32" name="直線コネクタ 31"/>
          <p:cNvCxnSpPr>
            <a:stCxn id="28" idx="3"/>
          </p:cNvCxnSpPr>
          <p:nvPr/>
        </p:nvCxnSpPr>
        <p:spPr bwMode="auto">
          <a:xfrm flipV="1">
            <a:off x="2101668" y="5252085"/>
            <a:ext cx="529669" cy="91202"/>
          </a:xfrm>
          <a:prstGeom prst="line">
            <a:avLst/>
          </a:prstGeom>
          <a:solidFill>
            <a:schemeClr val="accent1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33" name="テキスト ボックス 32"/>
          <p:cNvSpPr txBox="1"/>
          <p:nvPr/>
        </p:nvSpPr>
        <p:spPr>
          <a:xfrm>
            <a:off x="2564859" y="5060499"/>
            <a:ext cx="468217" cy="3052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ja-JP" altLang="en-US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直線コネクタ 33"/>
          <p:cNvCxnSpPr/>
          <p:nvPr/>
        </p:nvCxnSpPr>
        <p:spPr bwMode="auto">
          <a:xfrm>
            <a:off x="1634167" y="5208754"/>
            <a:ext cx="505649" cy="713608"/>
          </a:xfrm>
          <a:prstGeom prst="line">
            <a:avLst/>
          </a:prstGeom>
          <a:solidFill>
            <a:schemeClr val="accent1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35" name="テキスト ボックス 34"/>
          <p:cNvSpPr txBox="1"/>
          <p:nvPr/>
        </p:nvSpPr>
        <p:spPr>
          <a:xfrm>
            <a:off x="1941910" y="5892244"/>
            <a:ext cx="595873" cy="3052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ja-JP" altLang="en-US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417213" y="3894179"/>
            <a:ext cx="990493" cy="30523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V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lang="ja-JP" altLang="en-US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直線コネクタ 35"/>
          <p:cNvCxnSpPr/>
          <p:nvPr/>
        </p:nvCxnSpPr>
        <p:spPr bwMode="auto">
          <a:xfrm flipH="1" flipV="1">
            <a:off x="822813" y="4230850"/>
            <a:ext cx="394043" cy="1107757"/>
          </a:xfrm>
          <a:prstGeom prst="line">
            <a:avLst/>
          </a:prstGeom>
          <a:solidFill>
            <a:schemeClr val="accent1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grpSp>
        <p:nvGrpSpPr>
          <p:cNvPr id="40" name="グループ化 39"/>
          <p:cNvGrpSpPr/>
          <p:nvPr/>
        </p:nvGrpSpPr>
        <p:grpSpPr>
          <a:xfrm>
            <a:off x="6372924" y="1024257"/>
            <a:ext cx="2458113" cy="2284048"/>
            <a:chOff x="1496607" y="4739301"/>
            <a:chExt cx="3684620" cy="3494799"/>
          </a:xfrm>
        </p:grpSpPr>
        <p:sp>
          <p:nvSpPr>
            <p:cNvPr id="55" name="フリーフォーム 54"/>
            <p:cNvSpPr/>
            <p:nvPr/>
          </p:nvSpPr>
          <p:spPr bwMode="auto">
            <a:xfrm>
              <a:off x="4232595" y="4739301"/>
              <a:ext cx="720199" cy="852235"/>
            </a:xfrm>
            <a:custGeom>
              <a:avLst/>
              <a:gdLst>
                <a:gd name="connsiteX0" fmla="*/ 309455 w 595205"/>
                <a:gd name="connsiteY0" fmla="*/ 628866 h 640296"/>
                <a:gd name="connsiteX1" fmla="*/ 309455 w 595205"/>
                <a:gd name="connsiteY1" fmla="*/ 628866 h 640296"/>
                <a:gd name="connsiteX2" fmla="*/ 103715 w 595205"/>
                <a:gd name="connsiteY2" fmla="*/ 525996 h 640296"/>
                <a:gd name="connsiteX3" fmla="*/ 80855 w 595205"/>
                <a:gd name="connsiteY3" fmla="*/ 491706 h 640296"/>
                <a:gd name="connsiteX4" fmla="*/ 69425 w 595205"/>
                <a:gd name="connsiteY4" fmla="*/ 297396 h 640296"/>
                <a:gd name="connsiteX5" fmla="*/ 57995 w 595205"/>
                <a:gd name="connsiteY5" fmla="*/ 263106 h 640296"/>
                <a:gd name="connsiteX6" fmla="*/ 23705 w 595205"/>
                <a:gd name="connsiteY6" fmla="*/ 240246 h 640296"/>
                <a:gd name="connsiteX7" fmla="*/ 845 w 595205"/>
                <a:gd name="connsiteY7" fmla="*/ 205956 h 640296"/>
                <a:gd name="connsiteX8" fmla="*/ 35135 w 595205"/>
                <a:gd name="connsiteY8" fmla="*/ 68796 h 640296"/>
                <a:gd name="connsiteX9" fmla="*/ 69425 w 595205"/>
                <a:gd name="connsiteY9" fmla="*/ 57366 h 640296"/>
                <a:gd name="connsiteX10" fmla="*/ 80855 w 595205"/>
                <a:gd name="connsiteY10" fmla="*/ 23076 h 640296"/>
                <a:gd name="connsiteX11" fmla="*/ 172295 w 595205"/>
                <a:gd name="connsiteY11" fmla="*/ 11646 h 640296"/>
                <a:gd name="connsiteX12" fmla="*/ 206585 w 595205"/>
                <a:gd name="connsiteY12" fmla="*/ 80226 h 640296"/>
                <a:gd name="connsiteX13" fmla="*/ 240875 w 595205"/>
                <a:gd name="connsiteY13" fmla="*/ 114516 h 640296"/>
                <a:gd name="connsiteX14" fmla="*/ 332315 w 595205"/>
                <a:gd name="connsiteY14" fmla="*/ 205956 h 640296"/>
                <a:gd name="connsiteX15" fmla="*/ 366605 w 595205"/>
                <a:gd name="connsiteY15" fmla="*/ 217386 h 640296"/>
                <a:gd name="connsiteX16" fmla="*/ 446615 w 595205"/>
                <a:gd name="connsiteY16" fmla="*/ 297396 h 640296"/>
                <a:gd name="connsiteX17" fmla="*/ 480905 w 595205"/>
                <a:gd name="connsiteY17" fmla="*/ 320256 h 640296"/>
                <a:gd name="connsiteX18" fmla="*/ 538055 w 595205"/>
                <a:gd name="connsiteY18" fmla="*/ 388836 h 640296"/>
                <a:gd name="connsiteX19" fmla="*/ 595205 w 595205"/>
                <a:gd name="connsiteY19" fmla="*/ 491706 h 640296"/>
                <a:gd name="connsiteX20" fmla="*/ 583775 w 595205"/>
                <a:gd name="connsiteY20" fmla="*/ 594576 h 640296"/>
                <a:gd name="connsiteX21" fmla="*/ 480905 w 595205"/>
                <a:gd name="connsiteY21" fmla="*/ 628866 h 640296"/>
                <a:gd name="connsiteX22" fmla="*/ 446615 w 595205"/>
                <a:gd name="connsiteY22" fmla="*/ 640296 h 640296"/>
                <a:gd name="connsiteX23" fmla="*/ 309455 w 595205"/>
                <a:gd name="connsiteY23" fmla="*/ 628866 h 64029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</a:cxnLst>
              <a:rect l="l" t="t" r="r" b="b"/>
              <a:pathLst>
                <a:path w="595205" h="640296">
                  <a:moveTo>
                    <a:pt x="309455" y="628866"/>
                  </a:moveTo>
                  <a:lnTo>
                    <a:pt x="309455" y="628866"/>
                  </a:lnTo>
                  <a:cubicBezTo>
                    <a:pt x="240875" y="594576"/>
                    <a:pt x="169463" y="565445"/>
                    <a:pt x="103715" y="525996"/>
                  </a:cubicBezTo>
                  <a:cubicBezTo>
                    <a:pt x="91935" y="518928"/>
                    <a:pt x="82893" y="505291"/>
                    <a:pt x="80855" y="491706"/>
                  </a:cubicBezTo>
                  <a:cubicBezTo>
                    <a:pt x="71230" y="427542"/>
                    <a:pt x="75881" y="361956"/>
                    <a:pt x="69425" y="297396"/>
                  </a:cubicBezTo>
                  <a:cubicBezTo>
                    <a:pt x="68226" y="285408"/>
                    <a:pt x="65521" y="272514"/>
                    <a:pt x="57995" y="263106"/>
                  </a:cubicBezTo>
                  <a:cubicBezTo>
                    <a:pt x="49413" y="252379"/>
                    <a:pt x="35135" y="247866"/>
                    <a:pt x="23705" y="240246"/>
                  </a:cubicBezTo>
                  <a:cubicBezTo>
                    <a:pt x="16085" y="228816"/>
                    <a:pt x="1986" y="219646"/>
                    <a:pt x="845" y="205956"/>
                  </a:cubicBezTo>
                  <a:cubicBezTo>
                    <a:pt x="-1681" y="175646"/>
                    <a:pt x="-702" y="97466"/>
                    <a:pt x="35135" y="68796"/>
                  </a:cubicBezTo>
                  <a:cubicBezTo>
                    <a:pt x="44543" y="61270"/>
                    <a:pt x="57995" y="61176"/>
                    <a:pt x="69425" y="57366"/>
                  </a:cubicBezTo>
                  <a:cubicBezTo>
                    <a:pt x="73235" y="45936"/>
                    <a:pt x="73329" y="32484"/>
                    <a:pt x="80855" y="23076"/>
                  </a:cubicBezTo>
                  <a:cubicBezTo>
                    <a:pt x="111012" y="-14620"/>
                    <a:pt x="130380" y="3263"/>
                    <a:pt x="172295" y="11646"/>
                  </a:cubicBezTo>
                  <a:cubicBezTo>
                    <a:pt x="183751" y="46013"/>
                    <a:pt x="181966" y="50683"/>
                    <a:pt x="206585" y="80226"/>
                  </a:cubicBezTo>
                  <a:cubicBezTo>
                    <a:pt x="216933" y="92644"/>
                    <a:pt x="230951" y="101757"/>
                    <a:pt x="240875" y="114516"/>
                  </a:cubicBezTo>
                  <a:cubicBezTo>
                    <a:pt x="300394" y="191040"/>
                    <a:pt x="259325" y="174675"/>
                    <a:pt x="332315" y="205956"/>
                  </a:cubicBezTo>
                  <a:cubicBezTo>
                    <a:pt x="343389" y="210702"/>
                    <a:pt x="355175" y="213576"/>
                    <a:pt x="366605" y="217386"/>
                  </a:cubicBezTo>
                  <a:cubicBezTo>
                    <a:pt x="386723" y="277740"/>
                    <a:pt x="368010" y="244993"/>
                    <a:pt x="446615" y="297396"/>
                  </a:cubicBezTo>
                  <a:lnTo>
                    <a:pt x="480905" y="320256"/>
                  </a:lnTo>
                  <a:cubicBezTo>
                    <a:pt x="562593" y="442787"/>
                    <a:pt x="435380" y="256825"/>
                    <a:pt x="538055" y="388836"/>
                  </a:cubicBezTo>
                  <a:cubicBezTo>
                    <a:pt x="583908" y="447790"/>
                    <a:pt x="577959" y="439969"/>
                    <a:pt x="595205" y="491706"/>
                  </a:cubicBezTo>
                  <a:cubicBezTo>
                    <a:pt x="591395" y="525996"/>
                    <a:pt x="602298" y="565469"/>
                    <a:pt x="583775" y="594576"/>
                  </a:cubicBezTo>
                  <a:lnTo>
                    <a:pt x="480905" y="628866"/>
                  </a:lnTo>
                  <a:lnTo>
                    <a:pt x="446615" y="640296"/>
                  </a:lnTo>
                  <a:cubicBezTo>
                    <a:pt x="344482" y="627529"/>
                    <a:pt x="332315" y="630771"/>
                    <a:pt x="309455" y="628866"/>
                  </a:cubicBezTo>
                  <a:close/>
                </a:path>
              </a:pathLst>
            </a:custGeom>
            <a:solidFill>
              <a:schemeClr val="bg1"/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defTabSz="685800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kumimoji="0" lang="ja-JP" altLang="en-US" sz="1350">
                <a:latin typeface="Arial" charset="0"/>
                <a:ea typeface="ＭＳ Ｐゴシック" charset="-128"/>
              </a:endParaRPr>
            </a:p>
          </p:txBody>
        </p:sp>
        <p:sp>
          <p:nvSpPr>
            <p:cNvPr id="42" name="テキスト ボックス 41"/>
            <p:cNvSpPr txBox="1"/>
            <p:nvPr/>
          </p:nvSpPr>
          <p:spPr>
            <a:xfrm>
              <a:off x="3002251" y="5896491"/>
              <a:ext cx="583901" cy="5651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dirty="0">
                  <a:solidFill>
                    <a:schemeClr val="bg1"/>
                  </a:solidFill>
                </a:rPr>
                <a:t>＊</a:t>
              </a:r>
            </a:p>
          </p:txBody>
        </p:sp>
        <p:sp>
          <p:nvSpPr>
            <p:cNvPr id="43" name="テキスト ボックス 42"/>
            <p:cNvSpPr txBox="1"/>
            <p:nvPr/>
          </p:nvSpPr>
          <p:spPr>
            <a:xfrm>
              <a:off x="3121857" y="6360217"/>
              <a:ext cx="433186" cy="6122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sz="2000" dirty="0">
                  <a:solidFill>
                    <a:schemeClr val="bg1"/>
                  </a:solidFill>
                </a:rPr>
                <a:t>＊</a:t>
              </a:r>
            </a:p>
          </p:txBody>
        </p:sp>
        <p:sp>
          <p:nvSpPr>
            <p:cNvPr id="44" name="テキスト ボックス 43"/>
            <p:cNvSpPr txBox="1"/>
            <p:nvPr/>
          </p:nvSpPr>
          <p:spPr>
            <a:xfrm>
              <a:off x="2658575" y="6116255"/>
              <a:ext cx="551979" cy="5651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dirty="0">
                  <a:solidFill>
                    <a:schemeClr val="bg1"/>
                  </a:solidFill>
                </a:rPr>
                <a:t>＊</a:t>
              </a:r>
            </a:p>
          </p:txBody>
        </p:sp>
        <p:sp>
          <p:nvSpPr>
            <p:cNvPr id="45" name="テキスト ボックス 44"/>
            <p:cNvSpPr txBox="1"/>
            <p:nvPr/>
          </p:nvSpPr>
          <p:spPr>
            <a:xfrm>
              <a:off x="2112661" y="6131071"/>
              <a:ext cx="482101" cy="5651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dirty="0">
                  <a:solidFill>
                    <a:schemeClr val="bg1"/>
                  </a:solidFill>
                </a:rPr>
                <a:t>＊</a:t>
              </a:r>
            </a:p>
          </p:txBody>
        </p:sp>
        <p:cxnSp>
          <p:nvCxnSpPr>
            <p:cNvPr id="48" name="直線コネクタ 47"/>
            <p:cNvCxnSpPr/>
            <p:nvPr/>
          </p:nvCxnSpPr>
          <p:spPr bwMode="auto">
            <a:xfrm>
              <a:off x="3365898" y="6256490"/>
              <a:ext cx="777224" cy="1580819"/>
            </a:xfrm>
            <a:prstGeom prst="line">
              <a:avLst/>
            </a:prstGeom>
            <a:solidFill>
              <a:schemeClr val="accent1"/>
            </a:solidFill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49" name="テキスト ボックス 48"/>
            <p:cNvSpPr txBox="1"/>
            <p:nvPr/>
          </p:nvSpPr>
          <p:spPr>
            <a:xfrm>
              <a:off x="3899389" y="7769837"/>
              <a:ext cx="1281838" cy="4245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</a:t>
              </a:r>
              <a:r>
                <a:rPr lang="en-US" altLang="ja-JP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V</a:t>
              </a:r>
              <a:r>
                <a:rPr lang="en-US" altLang="ja-JP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lang="ja-JP" alt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テキスト ボックス 50"/>
            <p:cNvSpPr txBox="1"/>
            <p:nvPr/>
          </p:nvSpPr>
          <p:spPr>
            <a:xfrm>
              <a:off x="1496607" y="6887841"/>
              <a:ext cx="835285" cy="5651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</a:t>
              </a:r>
              <a:r>
                <a:rPr lang="en-US" altLang="ja-JP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ja-JP" alt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2" name="直線コネクタ 51"/>
            <p:cNvCxnSpPr/>
            <p:nvPr/>
          </p:nvCxnSpPr>
          <p:spPr bwMode="auto">
            <a:xfrm>
              <a:off x="3003759" y="6481674"/>
              <a:ext cx="285786" cy="1253631"/>
            </a:xfrm>
            <a:prstGeom prst="line">
              <a:avLst/>
            </a:prstGeom>
            <a:solidFill>
              <a:schemeClr val="accent1"/>
            </a:solidFill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53" name="テキスト ボックス 52"/>
            <p:cNvSpPr txBox="1"/>
            <p:nvPr/>
          </p:nvSpPr>
          <p:spPr>
            <a:xfrm>
              <a:off x="2894914" y="7668989"/>
              <a:ext cx="927164" cy="5651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</a:t>
              </a:r>
              <a:r>
                <a:rPr lang="en-US" altLang="ja-JP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ja-JP" alt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6" name="グループ化 55"/>
          <p:cNvGrpSpPr/>
          <p:nvPr/>
        </p:nvGrpSpPr>
        <p:grpSpPr>
          <a:xfrm>
            <a:off x="3487240" y="4426625"/>
            <a:ext cx="1995007" cy="1833069"/>
            <a:chOff x="4878741" y="5391857"/>
            <a:chExt cx="2946229" cy="2612949"/>
          </a:xfrm>
        </p:grpSpPr>
        <p:sp>
          <p:nvSpPr>
            <p:cNvPr id="58" name="テキスト ボックス 57"/>
            <p:cNvSpPr txBox="1"/>
            <p:nvPr/>
          </p:nvSpPr>
          <p:spPr>
            <a:xfrm>
              <a:off x="6397355" y="5833599"/>
              <a:ext cx="468098" cy="5264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dirty="0">
                  <a:solidFill>
                    <a:schemeClr val="bg1"/>
                  </a:solidFill>
                </a:rPr>
                <a:t>＊</a:t>
              </a:r>
            </a:p>
          </p:txBody>
        </p:sp>
        <p:sp>
          <p:nvSpPr>
            <p:cNvPr id="59" name="テキスト ボックス 58"/>
            <p:cNvSpPr txBox="1"/>
            <p:nvPr/>
          </p:nvSpPr>
          <p:spPr>
            <a:xfrm>
              <a:off x="5824981" y="6018641"/>
              <a:ext cx="498287" cy="5264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dirty="0">
                  <a:solidFill>
                    <a:schemeClr val="bg1"/>
                  </a:solidFill>
                </a:rPr>
                <a:t>＊</a:t>
              </a:r>
            </a:p>
          </p:txBody>
        </p:sp>
        <p:sp>
          <p:nvSpPr>
            <p:cNvPr id="60" name="テキスト ボックス 59"/>
            <p:cNvSpPr txBox="1"/>
            <p:nvPr/>
          </p:nvSpPr>
          <p:spPr>
            <a:xfrm>
              <a:off x="5502703" y="6171084"/>
              <a:ext cx="545384" cy="5264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dirty="0">
                  <a:solidFill>
                    <a:schemeClr val="bg1"/>
                  </a:solidFill>
                </a:rPr>
                <a:t>＊</a:t>
              </a:r>
            </a:p>
          </p:txBody>
        </p:sp>
        <p:cxnSp>
          <p:nvCxnSpPr>
            <p:cNvPr id="61" name="直線コネクタ 60"/>
            <p:cNvCxnSpPr/>
            <p:nvPr/>
          </p:nvCxnSpPr>
          <p:spPr bwMode="auto">
            <a:xfrm flipV="1">
              <a:off x="6783783" y="5695817"/>
              <a:ext cx="507055" cy="339594"/>
            </a:xfrm>
            <a:prstGeom prst="line">
              <a:avLst/>
            </a:prstGeom>
            <a:solidFill>
              <a:schemeClr val="accent1"/>
            </a:solidFill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62" name="テキスト ボックス 61"/>
            <p:cNvSpPr txBox="1"/>
            <p:nvPr/>
          </p:nvSpPr>
          <p:spPr>
            <a:xfrm>
              <a:off x="7165399" y="5391857"/>
              <a:ext cx="655080" cy="4350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</a:t>
              </a:r>
              <a:r>
                <a:rPr lang="en-US" altLang="ja-JP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lang="ja-JP" alt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3" name="直線コネクタ 62"/>
            <p:cNvCxnSpPr/>
            <p:nvPr/>
          </p:nvCxnSpPr>
          <p:spPr bwMode="auto">
            <a:xfrm>
              <a:off x="6204169" y="6322474"/>
              <a:ext cx="1073579" cy="1107921"/>
            </a:xfrm>
            <a:prstGeom prst="line">
              <a:avLst/>
            </a:prstGeom>
            <a:solidFill>
              <a:schemeClr val="accent1"/>
            </a:solidFill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64" name="テキスト ボックス 63"/>
            <p:cNvSpPr txBox="1"/>
            <p:nvPr/>
          </p:nvSpPr>
          <p:spPr>
            <a:xfrm>
              <a:off x="7169889" y="7293619"/>
              <a:ext cx="655081" cy="4350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</a:t>
              </a:r>
              <a:r>
                <a:rPr lang="en-US" altLang="ja-JP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lang="ja-JP" alt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5" name="直線コネクタ 64"/>
            <p:cNvCxnSpPr/>
            <p:nvPr/>
          </p:nvCxnSpPr>
          <p:spPr bwMode="auto">
            <a:xfrm flipH="1">
              <a:off x="5262262" y="6516463"/>
              <a:ext cx="528473" cy="1098910"/>
            </a:xfrm>
            <a:prstGeom prst="line">
              <a:avLst/>
            </a:prstGeom>
            <a:solidFill>
              <a:schemeClr val="accent1"/>
            </a:solidFill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66" name="テキスト ボックス 65"/>
            <p:cNvSpPr txBox="1"/>
            <p:nvPr/>
          </p:nvSpPr>
          <p:spPr>
            <a:xfrm>
              <a:off x="4878741" y="7569712"/>
              <a:ext cx="780632" cy="4350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</a:t>
              </a:r>
              <a:r>
                <a:rPr lang="en-US" altLang="ja-JP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ja-JP" alt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7" name="タイトル 1"/>
          <p:cNvSpPr txBox="1">
            <a:spLocks/>
          </p:cNvSpPr>
          <p:nvPr/>
        </p:nvSpPr>
        <p:spPr>
          <a:xfrm>
            <a:off x="164119" y="16211"/>
            <a:ext cx="3372313" cy="71153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</a:t>
            </a:r>
            <a:r>
              <a:rPr lang="en-US" altLang="ja-JP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altLang="ja-JP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テキスト ボックス 67"/>
          <p:cNvSpPr txBox="1"/>
          <p:nvPr/>
        </p:nvSpPr>
        <p:spPr>
          <a:xfrm>
            <a:off x="26905" y="611714"/>
            <a:ext cx="37596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3200" dirty="0"/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273733" y="3354659"/>
            <a:ext cx="28434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V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ype; 25.2%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3060732" y="625885"/>
            <a:ext cx="37596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3200" dirty="0"/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6052034" y="629425"/>
            <a:ext cx="37596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3200" dirty="0"/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30445" y="3656174"/>
            <a:ext cx="37596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kumimoji="1" lang="ja-JP" altLang="en-US" sz="3200" dirty="0"/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3053646" y="3670350"/>
            <a:ext cx="37596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kumimoji="1" lang="ja-JP" altLang="en-US" sz="3200" dirty="0"/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3233133" y="3368834"/>
            <a:ext cx="28434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V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V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ype; 20.4%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テキスト ボックス 77"/>
          <p:cNvSpPr txBox="1"/>
          <p:nvPr/>
        </p:nvSpPr>
        <p:spPr>
          <a:xfrm>
            <a:off x="5996262" y="3393642"/>
            <a:ext cx="32518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V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V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V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ype; 31.1%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テキスト ボックス 78"/>
          <p:cNvSpPr txBox="1"/>
          <p:nvPr/>
        </p:nvSpPr>
        <p:spPr>
          <a:xfrm>
            <a:off x="3247581" y="6360133"/>
            <a:ext cx="30441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V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V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ype;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6%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3530" y="6385451"/>
            <a:ext cx="32518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V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V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V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ype; 20.7%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テキスト ボックス 89"/>
          <p:cNvSpPr txBox="1"/>
          <p:nvPr/>
        </p:nvSpPr>
        <p:spPr>
          <a:xfrm>
            <a:off x="3412908" y="3088253"/>
            <a:ext cx="883971" cy="30523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V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lang="ja-JP" altLang="en-US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" name="直線コネクタ 12"/>
          <p:cNvCxnSpPr/>
          <p:nvPr/>
        </p:nvCxnSpPr>
        <p:spPr bwMode="auto">
          <a:xfrm flipH="1">
            <a:off x="3795868" y="2409803"/>
            <a:ext cx="375379" cy="715616"/>
          </a:xfrm>
          <a:prstGeom prst="line">
            <a:avLst/>
          </a:prstGeom>
          <a:solidFill>
            <a:schemeClr val="accent1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69" name="直線コネクタ 68"/>
          <p:cNvCxnSpPr/>
          <p:nvPr/>
        </p:nvCxnSpPr>
        <p:spPr bwMode="auto">
          <a:xfrm flipH="1">
            <a:off x="6753898" y="2144663"/>
            <a:ext cx="186449" cy="339064"/>
          </a:xfrm>
          <a:prstGeom prst="line">
            <a:avLst/>
          </a:prstGeom>
          <a:solidFill>
            <a:schemeClr val="accent1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</p:spTree>
    <p:extLst>
      <p:ext uri="{BB962C8B-B14F-4D97-AF65-F5344CB8AC3E}">
        <p14:creationId xmlns:p14="http://schemas.microsoft.com/office/powerpoint/2010/main" val="31263579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グループ化 11"/>
          <p:cNvGrpSpPr/>
          <p:nvPr/>
        </p:nvGrpSpPr>
        <p:grpSpPr>
          <a:xfrm>
            <a:off x="323962" y="3893574"/>
            <a:ext cx="2519999" cy="2553234"/>
            <a:chOff x="741389" y="4365104"/>
            <a:chExt cx="3360003" cy="3404312"/>
          </a:xfrm>
        </p:grpSpPr>
        <p:grpSp>
          <p:nvGrpSpPr>
            <p:cNvPr id="13" name="グループ化 12"/>
            <p:cNvGrpSpPr/>
            <p:nvPr/>
          </p:nvGrpSpPr>
          <p:grpSpPr>
            <a:xfrm>
              <a:off x="741389" y="4365104"/>
              <a:ext cx="3360003" cy="3404312"/>
              <a:chOff x="741389" y="4320791"/>
              <a:chExt cx="3360003" cy="3404312"/>
            </a:xfrm>
          </p:grpSpPr>
          <p:pic>
            <p:nvPicPr>
              <p:cNvPr id="23" name="Picture 3"/>
              <p:cNvPicPr>
                <a:picLocks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5731" t="53728" r="42010" b="22266"/>
              <a:stretch/>
            </p:blipFill>
            <p:spPr>
              <a:xfrm>
                <a:off x="741389" y="4365103"/>
                <a:ext cx="3360003" cy="3360000"/>
              </a:xfrm>
              <a:prstGeom prst="rect">
                <a:avLst/>
              </a:prstGeom>
            </p:spPr>
          </p:pic>
          <p:sp>
            <p:nvSpPr>
              <p:cNvPr id="24" name="フリーフォーム 23"/>
              <p:cNvSpPr/>
              <p:nvPr/>
            </p:nvSpPr>
            <p:spPr bwMode="auto">
              <a:xfrm>
                <a:off x="2189583" y="4320791"/>
                <a:ext cx="907795" cy="628399"/>
              </a:xfrm>
              <a:custGeom>
                <a:avLst/>
                <a:gdLst>
                  <a:gd name="connsiteX0" fmla="*/ 16407 w 907795"/>
                  <a:gd name="connsiteY0" fmla="*/ 0 h 571500"/>
                  <a:gd name="connsiteX1" fmla="*/ 16407 w 907795"/>
                  <a:gd name="connsiteY1" fmla="*/ 0 h 571500"/>
                  <a:gd name="connsiteX2" fmla="*/ 713637 w 907795"/>
                  <a:gd name="connsiteY2" fmla="*/ 11430 h 571500"/>
                  <a:gd name="connsiteX3" fmla="*/ 747927 w 907795"/>
                  <a:gd name="connsiteY3" fmla="*/ 22860 h 571500"/>
                  <a:gd name="connsiteX4" fmla="*/ 850797 w 907795"/>
                  <a:gd name="connsiteY4" fmla="*/ 34290 h 571500"/>
                  <a:gd name="connsiteX5" fmla="*/ 873657 w 907795"/>
                  <a:gd name="connsiteY5" fmla="*/ 68580 h 571500"/>
                  <a:gd name="connsiteX6" fmla="*/ 896517 w 907795"/>
                  <a:gd name="connsiteY6" fmla="*/ 182880 h 571500"/>
                  <a:gd name="connsiteX7" fmla="*/ 862227 w 907795"/>
                  <a:gd name="connsiteY7" fmla="*/ 514350 h 571500"/>
                  <a:gd name="connsiteX8" fmla="*/ 816507 w 907795"/>
                  <a:gd name="connsiteY8" fmla="*/ 548640 h 571500"/>
                  <a:gd name="connsiteX9" fmla="*/ 782217 w 907795"/>
                  <a:gd name="connsiteY9" fmla="*/ 571500 h 571500"/>
                  <a:gd name="connsiteX10" fmla="*/ 565047 w 907795"/>
                  <a:gd name="connsiteY10" fmla="*/ 537210 h 571500"/>
                  <a:gd name="connsiteX11" fmla="*/ 530757 w 907795"/>
                  <a:gd name="connsiteY11" fmla="*/ 514350 h 571500"/>
                  <a:gd name="connsiteX12" fmla="*/ 507897 w 907795"/>
                  <a:gd name="connsiteY12" fmla="*/ 480060 h 571500"/>
                  <a:gd name="connsiteX13" fmla="*/ 496467 w 907795"/>
                  <a:gd name="connsiteY13" fmla="*/ 445770 h 571500"/>
                  <a:gd name="connsiteX14" fmla="*/ 427887 w 907795"/>
                  <a:gd name="connsiteY14" fmla="*/ 377190 h 571500"/>
                  <a:gd name="connsiteX15" fmla="*/ 405027 w 907795"/>
                  <a:gd name="connsiteY15" fmla="*/ 342900 h 571500"/>
                  <a:gd name="connsiteX16" fmla="*/ 325017 w 907795"/>
                  <a:gd name="connsiteY16" fmla="*/ 297180 h 571500"/>
                  <a:gd name="connsiteX17" fmla="*/ 233577 w 907795"/>
                  <a:gd name="connsiteY17" fmla="*/ 262890 h 571500"/>
                  <a:gd name="connsiteX18" fmla="*/ 164997 w 907795"/>
                  <a:gd name="connsiteY18" fmla="*/ 217170 h 571500"/>
                  <a:gd name="connsiteX19" fmla="*/ 130707 w 907795"/>
                  <a:gd name="connsiteY19" fmla="*/ 194310 h 571500"/>
                  <a:gd name="connsiteX20" fmla="*/ 96417 w 907795"/>
                  <a:gd name="connsiteY20" fmla="*/ 182880 h 571500"/>
                  <a:gd name="connsiteX21" fmla="*/ 73557 w 907795"/>
                  <a:gd name="connsiteY21" fmla="*/ 148590 h 571500"/>
                  <a:gd name="connsiteX22" fmla="*/ 39267 w 907795"/>
                  <a:gd name="connsiteY22" fmla="*/ 125730 h 571500"/>
                  <a:gd name="connsiteX23" fmla="*/ 27837 w 907795"/>
                  <a:gd name="connsiteY23" fmla="*/ 91440 h 571500"/>
                  <a:gd name="connsiteX24" fmla="*/ 4977 w 907795"/>
                  <a:gd name="connsiteY24" fmla="*/ 57150 h 571500"/>
                  <a:gd name="connsiteX25" fmla="*/ 16407 w 907795"/>
                  <a:gd name="connsiteY25" fmla="*/ 0 h 5715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</a:cxnLst>
                <a:rect l="l" t="t" r="r" b="b"/>
                <a:pathLst>
                  <a:path w="907795" h="571500">
                    <a:moveTo>
                      <a:pt x="16407" y="0"/>
                    </a:moveTo>
                    <a:lnTo>
                      <a:pt x="16407" y="0"/>
                    </a:lnTo>
                    <a:lnTo>
                      <a:pt x="713637" y="11430"/>
                    </a:lnTo>
                    <a:cubicBezTo>
                      <a:pt x="725679" y="11806"/>
                      <a:pt x="736043" y="20879"/>
                      <a:pt x="747927" y="22860"/>
                    </a:cubicBezTo>
                    <a:cubicBezTo>
                      <a:pt x="781959" y="28532"/>
                      <a:pt x="816507" y="30480"/>
                      <a:pt x="850797" y="34290"/>
                    </a:cubicBezTo>
                    <a:cubicBezTo>
                      <a:pt x="858417" y="45720"/>
                      <a:pt x="867514" y="56293"/>
                      <a:pt x="873657" y="68580"/>
                    </a:cubicBezTo>
                    <a:cubicBezTo>
                      <a:pt x="889617" y="100499"/>
                      <a:pt x="892305" y="153394"/>
                      <a:pt x="896517" y="182880"/>
                    </a:cubicBezTo>
                    <a:cubicBezTo>
                      <a:pt x="895795" y="201654"/>
                      <a:pt x="938519" y="438058"/>
                      <a:pt x="862227" y="514350"/>
                    </a:cubicBezTo>
                    <a:cubicBezTo>
                      <a:pt x="848757" y="527820"/>
                      <a:pt x="832009" y="537567"/>
                      <a:pt x="816507" y="548640"/>
                    </a:cubicBezTo>
                    <a:cubicBezTo>
                      <a:pt x="805329" y="556625"/>
                      <a:pt x="793647" y="563880"/>
                      <a:pt x="782217" y="571500"/>
                    </a:cubicBezTo>
                    <a:cubicBezTo>
                      <a:pt x="639884" y="562011"/>
                      <a:pt x="648278" y="584770"/>
                      <a:pt x="565047" y="537210"/>
                    </a:cubicBezTo>
                    <a:cubicBezTo>
                      <a:pt x="553120" y="530394"/>
                      <a:pt x="542187" y="521970"/>
                      <a:pt x="530757" y="514350"/>
                    </a:cubicBezTo>
                    <a:cubicBezTo>
                      <a:pt x="523137" y="502920"/>
                      <a:pt x="514040" y="492347"/>
                      <a:pt x="507897" y="480060"/>
                    </a:cubicBezTo>
                    <a:cubicBezTo>
                      <a:pt x="502509" y="469284"/>
                      <a:pt x="503864" y="455280"/>
                      <a:pt x="496467" y="445770"/>
                    </a:cubicBezTo>
                    <a:cubicBezTo>
                      <a:pt x="476619" y="420251"/>
                      <a:pt x="445820" y="404089"/>
                      <a:pt x="427887" y="377190"/>
                    </a:cubicBezTo>
                    <a:cubicBezTo>
                      <a:pt x="420267" y="365760"/>
                      <a:pt x="414741" y="352614"/>
                      <a:pt x="405027" y="342900"/>
                    </a:cubicBezTo>
                    <a:cubicBezTo>
                      <a:pt x="386462" y="324335"/>
                      <a:pt x="345935" y="309133"/>
                      <a:pt x="325017" y="297180"/>
                    </a:cubicBezTo>
                    <a:cubicBezTo>
                      <a:pt x="261625" y="260956"/>
                      <a:pt x="322493" y="280673"/>
                      <a:pt x="233577" y="262890"/>
                    </a:cubicBezTo>
                    <a:lnTo>
                      <a:pt x="164997" y="217170"/>
                    </a:lnTo>
                    <a:cubicBezTo>
                      <a:pt x="153567" y="209550"/>
                      <a:pt x="143739" y="198654"/>
                      <a:pt x="130707" y="194310"/>
                    </a:cubicBezTo>
                    <a:lnTo>
                      <a:pt x="96417" y="182880"/>
                    </a:lnTo>
                    <a:cubicBezTo>
                      <a:pt x="88797" y="171450"/>
                      <a:pt x="83271" y="158304"/>
                      <a:pt x="73557" y="148590"/>
                    </a:cubicBezTo>
                    <a:cubicBezTo>
                      <a:pt x="63843" y="138876"/>
                      <a:pt x="47849" y="136457"/>
                      <a:pt x="39267" y="125730"/>
                    </a:cubicBezTo>
                    <a:cubicBezTo>
                      <a:pt x="31741" y="116322"/>
                      <a:pt x="33225" y="102216"/>
                      <a:pt x="27837" y="91440"/>
                    </a:cubicBezTo>
                    <a:cubicBezTo>
                      <a:pt x="21694" y="79153"/>
                      <a:pt x="11120" y="69437"/>
                      <a:pt x="4977" y="57150"/>
                    </a:cubicBezTo>
                    <a:cubicBezTo>
                      <a:pt x="-411" y="46374"/>
                      <a:pt x="-6453" y="22860"/>
                      <a:pt x="16407" y="0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68580" tIns="34290" rIns="68580" bIns="34290" numCol="1" rtlCol="0" anchor="t" anchorCtr="0" compatLnSpc="1">
                <a:prstTxWarp prst="textNoShape">
                  <a:avLst/>
                </a:prstTxWarp>
              </a:bodyPr>
              <a:lstStyle/>
              <a:p>
                <a:pPr defTabSz="68580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endParaRPr kumimoji="0" lang="ja-JP" altLang="en-US" sz="1350">
                  <a:latin typeface="Arial" charset="0"/>
                  <a:ea typeface="ＭＳ Ｐゴシック" charset="-128"/>
                </a:endParaRPr>
              </a:p>
            </p:txBody>
          </p:sp>
        </p:grpSp>
        <p:sp>
          <p:nvSpPr>
            <p:cNvPr id="14" name="テキスト ボックス 13"/>
            <p:cNvSpPr txBox="1"/>
            <p:nvPr/>
          </p:nvSpPr>
          <p:spPr>
            <a:xfrm>
              <a:off x="2301267" y="5223765"/>
              <a:ext cx="396087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dirty="0">
                  <a:solidFill>
                    <a:srgbClr val="FF0000"/>
                  </a:solidFill>
                </a:rPr>
                <a:t>＊</a:t>
              </a: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2110209" y="5811759"/>
              <a:ext cx="392249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dirty="0">
                  <a:solidFill>
                    <a:srgbClr val="FF0000"/>
                  </a:solidFill>
                </a:rPr>
                <a:t>＊</a:t>
              </a: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1582307" y="5816697"/>
              <a:ext cx="462101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dirty="0">
                  <a:solidFill>
                    <a:srgbClr val="FF0000"/>
                  </a:solidFill>
                </a:rPr>
                <a:t>＊</a:t>
              </a:r>
            </a:p>
          </p:txBody>
        </p:sp>
        <p:cxnSp>
          <p:nvCxnSpPr>
            <p:cNvPr id="17" name="直線コネクタ 16"/>
            <p:cNvCxnSpPr/>
            <p:nvPr/>
          </p:nvCxnSpPr>
          <p:spPr bwMode="auto">
            <a:xfrm flipV="1">
              <a:off x="2660936" y="5272707"/>
              <a:ext cx="702195" cy="156725"/>
            </a:xfrm>
            <a:prstGeom prst="line">
              <a:avLst/>
            </a:prstGeom>
            <a:solidFill>
              <a:schemeClr val="accent1"/>
            </a:solidFill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18" name="テキスト ボックス 17"/>
            <p:cNvSpPr txBox="1"/>
            <p:nvPr/>
          </p:nvSpPr>
          <p:spPr>
            <a:xfrm>
              <a:off x="3297298" y="4990064"/>
              <a:ext cx="589389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en-US" altLang="ja-JP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lang="ja-JP" alt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9" name="直線コネクタ 18"/>
            <p:cNvCxnSpPr/>
            <p:nvPr/>
          </p:nvCxnSpPr>
          <p:spPr bwMode="auto">
            <a:xfrm flipH="1" flipV="1">
              <a:off x="2375801" y="6151949"/>
              <a:ext cx="21549" cy="709695"/>
            </a:xfrm>
            <a:prstGeom prst="line">
              <a:avLst/>
            </a:prstGeom>
            <a:solidFill>
              <a:schemeClr val="accent1"/>
            </a:solidFill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20" name="テキスト ボックス 19"/>
            <p:cNvSpPr txBox="1"/>
            <p:nvPr/>
          </p:nvSpPr>
          <p:spPr>
            <a:xfrm>
              <a:off x="2137737" y="6770467"/>
              <a:ext cx="634757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en-US" altLang="ja-JP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lang="ja-JP" alt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1" name="直線コネクタ 20"/>
            <p:cNvCxnSpPr/>
            <p:nvPr/>
          </p:nvCxnSpPr>
          <p:spPr bwMode="auto">
            <a:xfrm flipV="1">
              <a:off x="1181528" y="6116609"/>
              <a:ext cx="589695" cy="544305"/>
            </a:xfrm>
            <a:prstGeom prst="line">
              <a:avLst/>
            </a:prstGeom>
            <a:solidFill>
              <a:schemeClr val="accent1"/>
            </a:solidFill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22" name="テキスト ボックス 21"/>
            <p:cNvSpPr txBox="1"/>
            <p:nvPr/>
          </p:nvSpPr>
          <p:spPr>
            <a:xfrm>
              <a:off x="779912" y="6587060"/>
              <a:ext cx="752280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en-US" altLang="ja-JP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ja-JP" alt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5" name="グループ化 24"/>
          <p:cNvGrpSpPr/>
          <p:nvPr/>
        </p:nvGrpSpPr>
        <p:grpSpPr>
          <a:xfrm>
            <a:off x="3436700" y="3794238"/>
            <a:ext cx="2520000" cy="2628012"/>
            <a:chOff x="3347864" y="4221088"/>
            <a:chExt cx="3359994" cy="3504016"/>
          </a:xfrm>
        </p:grpSpPr>
        <p:grpSp>
          <p:nvGrpSpPr>
            <p:cNvPr id="26" name="グループ化 25"/>
            <p:cNvGrpSpPr/>
            <p:nvPr/>
          </p:nvGrpSpPr>
          <p:grpSpPr>
            <a:xfrm>
              <a:off x="3347864" y="4221088"/>
              <a:ext cx="3359994" cy="3504016"/>
              <a:chOff x="3347864" y="4221088"/>
              <a:chExt cx="3359994" cy="3504016"/>
            </a:xfrm>
          </p:grpSpPr>
          <p:pic>
            <p:nvPicPr>
              <p:cNvPr id="36" name="Picture 3"/>
              <p:cNvPicPr>
                <a:picLocks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1724" t="58907" r="41651" b="12592"/>
              <a:stretch/>
            </p:blipFill>
            <p:spPr>
              <a:xfrm>
                <a:off x="3347864" y="4365104"/>
                <a:ext cx="3359994" cy="3360000"/>
              </a:xfrm>
              <a:prstGeom prst="rect">
                <a:avLst/>
              </a:prstGeom>
            </p:spPr>
          </p:pic>
          <p:sp>
            <p:nvSpPr>
              <p:cNvPr id="37" name="フリーフォーム 36"/>
              <p:cNvSpPr/>
              <p:nvPr/>
            </p:nvSpPr>
            <p:spPr bwMode="auto">
              <a:xfrm>
                <a:off x="4983351" y="4221088"/>
                <a:ext cx="991263" cy="728102"/>
              </a:xfrm>
              <a:custGeom>
                <a:avLst/>
                <a:gdLst>
                  <a:gd name="connsiteX0" fmla="*/ 45849 w 914547"/>
                  <a:gd name="connsiteY0" fmla="*/ 0 h 594360"/>
                  <a:gd name="connsiteX1" fmla="*/ 45849 w 914547"/>
                  <a:gd name="connsiteY1" fmla="*/ 0 h 594360"/>
                  <a:gd name="connsiteX2" fmla="*/ 731649 w 914547"/>
                  <a:gd name="connsiteY2" fmla="*/ 11430 h 594360"/>
                  <a:gd name="connsiteX3" fmla="*/ 834519 w 914547"/>
                  <a:gd name="connsiteY3" fmla="*/ 45720 h 594360"/>
                  <a:gd name="connsiteX4" fmla="*/ 868809 w 914547"/>
                  <a:gd name="connsiteY4" fmla="*/ 57150 h 594360"/>
                  <a:gd name="connsiteX5" fmla="*/ 914529 w 914547"/>
                  <a:gd name="connsiteY5" fmla="*/ 125730 h 594360"/>
                  <a:gd name="connsiteX6" fmla="*/ 903099 w 914547"/>
                  <a:gd name="connsiteY6" fmla="*/ 480060 h 594360"/>
                  <a:gd name="connsiteX7" fmla="*/ 868809 w 914547"/>
                  <a:gd name="connsiteY7" fmla="*/ 514350 h 594360"/>
                  <a:gd name="connsiteX8" fmla="*/ 674499 w 914547"/>
                  <a:gd name="connsiteY8" fmla="*/ 548640 h 594360"/>
                  <a:gd name="connsiteX9" fmla="*/ 617349 w 914547"/>
                  <a:gd name="connsiteY9" fmla="*/ 560070 h 594360"/>
                  <a:gd name="connsiteX10" fmla="*/ 560199 w 914547"/>
                  <a:gd name="connsiteY10" fmla="*/ 582930 h 594360"/>
                  <a:gd name="connsiteX11" fmla="*/ 525909 w 914547"/>
                  <a:gd name="connsiteY11" fmla="*/ 594360 h 594360"/>
                  <a:gd name="connsiteX12" fmla="*/ 491619 w 914547"/>
                  <a:gd name="connsiteY12" fmla="*/ 560070 h 594360"/>
                  <a:gd name="connsiteX13" fmla="*/ 457329 w 914547"/>
                  <a:gd name="connsiteY13" fmla="*/ 548640 h 594360"/>
                  <a:gd name="connsiteX14" fmla="*/ 411609 w 914547"/>
                  <a:gd name="connsiteY14" fmla="*/ 468630 h 594360"/>
                  <a:gd name="connsiteX15" fmla="*/ 400179 w 914547"/>
                  <a:gd name="connsiteY15" fmla="*/ 422910 h 594360"/>
                  <a:gd name="connsiteX16" fmla="*/ 377319 w 914547"/>
                  <a:gd name="connsiteY16" fmla="*/ 354330 h 594360"/>
                  <a:gd name="connsiteX17" fmla="*/ 331599 w 914547"/>
                  <a:gd name="connsiteY17" fmla="*/ 285750 h 594360"/>
                  <a:gd name="connsiteX18" fmla="*/ 297309 w 914547"/>
                  <a:gd name="connsiteY18" fmla="*/ 274320 h 594360"/>
                  <a:gd name="connsiteX19" fmla="*/ 263019 w 914547"/>
                  <a:gd name="connsiteY19" fmla="*/ 251460 h 594360"/>
                  <a:gd name="connsiteX20" fmla="*/ 194439 w 914547"/>
                  <a:gd name="connsiteY20" fmla="*/ 228600 h 594360"/>
                  <a:gd name="connsiteX21" fmla="*/ 160149 w 914547"/>
                  <a:gd name="connsiteY21" fmla="*/ 217170 h 594360"/>
                  <a:gd name="connsiteX22" fmla="*/ 91569 w 914547"/>
                  <a:gd name="connsiteY22" fmla="*/ 205740 h 594360"/>
                  <a:gd name="connsiteX23" fmla="*/ 22989 w 914547"/>
                  <a:gd name="connsiteY23" fmla="*/ 182880 h 594360"/>
                  <a:gd name="connsiteX24" fmla="*/ 129 w 914547"/>
                  <a:gd name="connsiteY24" fmla="*/ 102870 h 594360"/>
                  <a:gd name="connsiteX25" fmla="*/ 45849 w 914547"/>
                  <a:gd name="connsiteY25" fmla="*/ 0 h 5943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</a:cxnLst>
                <a:rect l="l" t="t" r="r" b="b"/>
                <a:pathLst>
                  <a:path w="914547" h="594360">
                    <a:moveTo>
                      <a:pt x="45849" y="0"/>
                    </a:moveTo>
                    <a:lnTo>
                      <a:pt x="45849" y="0"/>
                    </a:lnTo>
                    <a:cubicBezTo>
                      <a:pt x="274449" y="3810"/>
                      <a:pt x="503253" y="1048"/>
                      <a:pt x="731649" y="11430"/>
                    </a:cubicBezTo>
                    <a:lnTo>
                      <a:pt x="834519" y="45720"/>
                    </a:lnTo>
                    <a:lnTo>
                      <a:pt x="868809" y="57150"/>
                    </a:lnTo>
                    <a:cubicBezTo>
                      <a:pt x="884049" y="80010"/>
                      <a:pt x="915415" y="98270"/>
                      <a:pt x="914529" y="125730"/>
                    </a:cubicBezTo>
                    <a:cubicBezTo>
                      <a:pt x="910719" y="243840"/>
                      <a:pt x="916906" y="362698"/>
                      <a:pt x="903099" y="480060"/>
                    </a:cubicBezTo>
                    <a:cubicBezTo>
                      <a:pt x="901210" y="496114"/>
                      <a:pt x="883896" y="508547"/>
                      <a:pt x="868809" y="514350"/>
                    </a:cubicBezTo>
                    <a:cubicBezTo>
                      <a:pt x="828621" y="529807"/>
                      <a:pt x="723268" y="540512"/>
                      <a:pt x="674499" y="548640"/>
                    </a:cubicBezTo>
                    <a:cubicBezTo>
                      <a:pt x="655336" y="551834"/>
                      <a:pt x="635957" y="554488"/>
                      <a:pt x="617349" y="560070"/>
                    </a:cubicBezTo>
                    <a:cubicBezTo>
                      <a:pt x="597697" y="565966"/>
                      <a:pt x="579410" y="575726"/>
                      <a:pt x="560199" y="582930"/>
                    </a:cubicBezTo>
                    <a:cubicBezTo>
                      <a:pt x="548918" y="587160"/>
                      <a:pt x="537339" y="590550"/>
                      <a:pt x="525909" y="594360"/>
                    </a:cubicBezTo>
                    <a:cubicBezTo>
                      <a:pt x="514479" y="582930"/>
                      <a:pt x="505069" y="569036"/>
                      <a:pt x="491619" y="560070"/>
                    </a:cubicBezTo>
                    <a:cubicBezTo>
                      <a:pt x="481594" y="553387"/>
                      <a:pt x="466737" y="556166"/>
                      <a:pt x="457329" y="548640"/>
                    </a:cubicBezTo>
                    <a:cubicBezTo>
                      <a:pt x="445486" y="539165"/>
                      <a:pt x="415225" y="478273"/>
                      <a:pt x="411609" y="468630"/>
                    </a:cubicBezTo>
                    <a:cubicBezTo>
                      <a:pt x="406093" y="453921"/>
                      <a:pt x="404693" y="437957"/>
                      <a:pt x="400179" y="422910"/>
                    </a:cubicBezTo>
                    <a:cubicBezTo>
                      <a:pt x="393255" y="399830"/>
                      <a:pt x="384939" y="377190"/>
                      <a:pt x="377319" y="354330"/>
                    </a:cubicBezTo>
                    <a:cubicBezTo>
                      <a:pt x="365336" y="318380"/>
                      <a:pt x="368293" y="310213"/>
                      <a:pt x="331599" y="285750"/>
                    </a:cubicBezTo>
                    <a:cubicBezTo>
                      <a:pt x="321574" y="279067"/>
                      <a:pt x="308085" y="279708"/>
                      <a:pt x="297309" y="274320"/>
                    </a:cubicBezTo>
                    <a:cubicBezTo>
                      <a:pt x="285022" y="268177"/>
                      <a:pt x="275572" y="257039"/>
                      <a:pt x="263019" y="251460"/>
                    </a:cubicBezTo>
                    <a:cubicBezTo>
                      <a:pt x="240999" y="241673"/>
                      <a:pt x="217299" y="236220"/>
                      <a:pt x="194439" y="228600"/>
                    </a:cubicBezTo>
                    <a:cubicBezTo>
                      <a:pt x="183009" y="224790"/>
                      <a:pt x="172033" y="219151"/>
                      <a:pt x="160149" y="217170"/>
                    </a:cubicBezTo>
                    <a:cubicBezTo>
                      <a:pt x="137289" y="213360"/>
                      <a:pt x="114052" y="211361"/>
                      <a:pt x="91569" y="205740"/>
                    </a:cubicBezTo>
                    <a:cubicBezTo>
                      <a:pt x="68192" y="199896"/>
                      <a:pt x="22989" y="182880"/>
                      <a:pt x="22989" y="182880"/>
                    </a:cubicBezTo>
                    <a:cubicBezTo>
                      <a:pt x="16598" y="163708"/>
                      <a:pt x="1434" y="121136"/>
                      <a:pt x="129" y="102870"/>
                    </a:cubicBezTo>
                    <a:cubicBezTo>
                      <a:pt x="-2586" y="64867"/>
                      <a:pt x="38229" y="17145"/>
                      <a:pt x="45849" y="0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68580" tIns="34290" rIns="68580" bIns="34290" numCol="1" rtlCol="0" anchor="t" anchorCtr="0" compatLnSpc="1">
                <a:prstTxWarp prst="textNoShape">
                  <a:avLst/>
                </a:prstTxWarp>
              </a:bodyPr>
              <a:lstStyle/>
              <a:p>
                <a:pPr defTabSz="68580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endParaRPr kumimoji="0" lang="ja-JP" altLang="en-US" sz="1350">
                  <a:latin typeface="Arial" charset="0"/>
                  <a:ea typeface="ＭＳ Ｐゴシック" charset="-128"/>
                </a:endParaRPr>
              </a:p>
            </p:txBody>
          </p:sp>
        </p:grpSp>
        <p:sp>
          <p:nvSpPr>
            <p:cNvPr id="27" name="テキスト ボックス 26"/>
            <p:cNvSpPr txBox="1"/>
            <p:nvPr/>
          </p:nvSpPr>
          <p:spPr>
            <a:xfrm>
              <a:off x="5140178" y="5181037"/>
              <a:ext cx="288031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dirty="0">
                  <a:solidFill>
                    <a:srgbClr val="FF0000"/>
                  </a:solidFill>
                </a:rPr>
                <a:t>＊</a:t>
              </a:r>
            </a:p>
          </p:txBody>
        </p:sp>
        <p:sp>
          <p:nvSpPr>
            <p:cNvPr id="28" name="テキスト ボックス 27"/>
            <p:cNvSpPr txBox="1"/>
            <p:nvPr/>
          </p:nvSpPr>
          <p:spPr>
            <a:xfrm>
              <a:off x="4771116" y="5444744"/>
              <a:ext cx="419470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dirty="0">
                  <a:solidFill>
                    <a:srgbClr val="FF0000"/>
                  </a:solidFill>
                </a:rPr>
                <a:t>＊</a:t>
              </a:r>
            </a:p>
          </p:txBody>
        </p:sp>
        <p:sp>
          <p:nvSpPr>
            <p:cNvPr id="29" name="テキスト ボックス 28"/>
            <p:cNvSpPr txBox="1"/>
            <p:nvPr/>
          </p:nvSpPr>
          <p:spPr>
            <a:xfrm>
              <a:off x="4115628" y="5321684"/>
              <a:ext cx="449326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dirty="0">
                  <a:solidFill>
                    <a:srgbClr val="FF0000"/>
                  </a:solidFill>
                </a:rPr>
                <a:t>＊</a:t>
              </a:r>
            </a:p>
          </p:txBody>
        </p:sp>
        <p:cxnSp>
          <p:nvCxnSpPr>
            <p:cNvPr id="30" name="直線コネクタ 29"/>
            <p:cNvCxnSpPr/>
            <p:nvPr/>
          </p:nvCxnSpPr>
          <p:spPr bwMode="auto">
            <a:xfrm>
              <a:off x="5495871" y="5425859"/>
              <a:ext cx="589896" cy="60736"/>
            </a:xfrm>
            <a:prstGeom prst="line">
              <a:avLst/>
            </a:prstGeom>
            <a:solidFill>
              <a:schemeClr val="accent1"/>
            </a:solidFill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31" name="テキスト ボックス 30"/>
            <p:cNvSpPr txBox="1"/>
            <p:nvPr/>
          </p:nvSpPr>
          <p:spPr>
            <a:xfrm>
              <a:off x="6033590" y="5261613"/>
              <a:ext cx="559912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en-US" altLang="ja-JP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lang="ja-JP" alt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2" name="直線コネクタ 31"/>
            <p:cNvCxnSpPr/>
            <p:nvPr/>
          </p:nvCxnSpPr>
          <p:spPr bwMode="auto">
            <a:xfrm>
              <a:off x="5104549" y="5759152"/>
              <a:ext cx="489643" cy="636843"/>
            </a:xfrm>
            <a:prstGeom prst="line">
              <a:avLst/>
            </a:prstGeom>
            <a:solidFill>
              <a:schemeClr val="accent1"/>
            </a:solidFill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33" name="テキスト ボックス 32"/>
            <p:cNvSpPr txBox="1"/>
            <p:nvPr/>
          </p:nvSpPr>
          <p:spPr>
            <a:xfrm>
              <a:off x="5393394" y="6315421"/>
              <a:ext cx="559912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en-US" altLang="ja-JP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lang="ja-JP" alt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4" name="直線コネクタ 33"/>
            <p:cNvCxnSpPr/>
            <p:nvPr/>
          </p:nvCxnSpPr>
          <p:spPr bwMode="auto">
            <a:xfrm flipV="1">
              <a:off x="4205212" y="5660041"/>
              <a:ext cx="161842" cy="1182191"/>
            </a:xfrm>
            <a:prstGeom prst="line">
              <a:avLst/>
            </a:prstGeom>
            <a:solidFill>
              <a:schemeClr val="accent1"/>
            </a:solidFill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35" name="テキスト ボックス 34"/>
            <p:cNvSpPr txBox="1"/>
            <p:nvPr/>
          </p:nvSpPr>
          <p:spPr>
            <a:xfrm>
              <a:off x="3941696" y="6765332"/>
              <a:ext cx="661715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en-US" altLang="ja-JP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ja-JP" alt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8" name="グループ化 37"/>
          <p:cNvGrpSpPr/>
          <p:nvPr/>
        </p:nvGrpSpPr>
        <p:grpSpPr>
          <a:xfrm>
            <a:off x="6388749" y="3794238"/>
            <a:ext cx="2595375" cy="2628012"/>
            <a:chOff x="6160770" y="4221088"/>
            <a:chExt cx="3460494" cy="3504016"/>
          </a:xfrm>
        </p:grpSpPr>
        <p:grpSp>
          <p:nvGrpSpPr>
            <p:cNvPr id="39" name="グループ化 38"/>
            <p:cNvGrpSpPr/>
            <p:nvPr/>
          </p:nvGrpSpPr>
          <p:grpSpPr>
            <a:xfrm>
              <a:off x="6160770" y="4221088"/>
              <a:ext cx="3460494" cy="3504016"/>
              <a:chOff x="6160770" y="4221088"/>
              <a:chExt cx="3460494" cy="3504016"/>
            </a:xfrm>
          </p:grpSpPr>
          <p:pic>
            <p:nvPicPr>
              <p:cNvPr id="49" name="Picture 3"/>
              <p:cNvPicPr>
                <a:picLocks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5839" t="53255" r="42429" b="24591"/>
              <a:stretch/>
            </p:blipFill>
            <p:spPr>
              <a:xfrm>
                <a:off x="6261270" y="4365104"/>
                <a:ext cx="3359994" cy="3360000"/>
              </a:xfrm>
              <a:prstGeom prst="rect">
                <a:avLst/>
              </a:prstGeom>
            </p:spPr>
          </p:pic>
          <p:sp>
            <p:nvSpPr>
              <p:cNvPr id="50" name="フリーフォーム 49"/>
              <p:cNvSpPr/>
              <p:nvPr/>
            </p:nvSpPr>
            <p:spPr bwMode="auto">
              <a:xfrm>
                <a:off x="7956376" y="4221088"/>
                <a:ext cx="707514" cy="432048"/>
              </a:xfrm>
              <a:custGeom>
                <a:avLst/>
                <a:gdLst>
                  <a:gd name="connsiteX0" fmla="*/ 0 w 491490"/>
                  <a:gd name="connsiteY0" fmla="*/ 22860 h 354330"/>
                  <a:gd name="connsiteX1" fmla="*/ 0 w 491490"/>
                  <a:gd name="connsiteY1" fmla="*/ 22860 h 354330"/>
                  <a:gd name="connsiteX2" fmla="*/ 114300 w 491490"/>
                  <a:gd name="connsiteY2" fmla="*/ 34290 h 354330"/>
                  <a:gd name="connsiteX3" fmla="*/ 274320 w 491490"/>
                  <a:gd name="connsiteY3" fmla="*/ 45720 h 354330"/>
                  <a:gd name="connsiteX4" fmla="*/ 342900 w 491490"/>
                  <a:gd name="connsiteY4" fmla="*/ 68580 h 354330"/>
                  <a:gd name="connsiteX5" fmla="*/ 377190 w 491490"/>
                  <a:gd name="connsiteY5" fmla="*/ 80010 h 354330"/>
                  <a:gd name="connsiteX6" fmla="*/ 411480 w 491490"/>
                  <a:gd name="connsiteY6" fmla="*/ 91440 h 354330"/>
                  <a:gd name="connsiteX7" fmla="*/ 434340 w 491490"/>
                  <a:gd name="connsiteY7" fmla="*/ 125730 h 354330"/>
                  <a:gd name="connsiteX8" fmla="*/ 468630 w 491490"/>
                  <a:gd name="connsiteY8" fmla="*/ 137160 h 354330"/>
                  <a:gd name="connsiteX9" fmla="*/ 480060 w 491490"/>
                  <a:gd name="connsiteY9" fmla="*/ 182880 h 354330"/>
                  <a:gd name="connsiteX10" fmla="*/ 491490 w 491490"/>
                  <a:gd name="connsiteY10" fmla="*/ 217170 h 354330"/>
                  <a:gd name="connsiteX11" fmla="*/ 480060 w 491490"/>
                  <a:gd name="connsiteY11" fmla="*/ 331470 h 354330"/>
                  <a:gd name="connsiteX12" fmla="*/ 445770 w 491490"/>
                  <a:gd name="connsiteY12" fmla="*/ 354330 h 354330"/>
                  <a:gd name="connsiteX13" fmla="*/ 194310 w 491490"/>
                  <a:gd name="connsiteY13" fmla="*/ 331470 h 354330"/>
                  <a:gd name="connsiteX14" fmla="*/ 171450 w 491490"/>
                  <a:gd name="connsiteY14" fmla="*/ 240030 h 354330"/>
                  <a:gd name="connsiteX15" fmla="*/ 160020 w 491490"/>
                  <a:gd name="connsiteY15" fmla="*/ 160020 h 354330"/>
                  <a:gd name="connsiteX16" fmla="*/ 137160 w 491490"/>
                  <a:gd name="connsiteY16" fmla="*/ 114300 h 354330"/>
                  <a:gd name="connsiteX17" fmla="*/ 114300 w 491490"/>
                  <a:gd name="connsiteY17" fmla="*/ 80010 h 354330"/>
                  <a:gd name="connsiteX18" fmla="*/ 80010 w 491490"/>
                  <a:gd name="connsiteY18" fmla="*/ 68580 h 354330"/>
                  <a:gd name="connsiteX19" fmla="*/ 68580 w 491490"/>
                  <a:gd name="connsiteY19" fmla="*/ 34290 h 354330"/>
                  <a:gd name="connsiteX20" fmla="*/ 45720 w 491490"/>
                  <a:gd name="connsiteY20" fmla="*/ 0 h 354330"/>
                  <a:gd name="connsiteX21" fmla="*/ 160020 w 491490"/>
                  <a:gd name="connsiteY21" fmla="*/ 91440 h 3543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</a:cxnLst>
                <a:rect l="l" t="t" r="r" b="b"/>
                <a:pathLst>
                  <a:path w="491490" h="354330">
                    <a:moveTo>
                      <a:pt x="0" y="22860"/>
                    </a:moveTo>
                    <a:lnTo>
                      <a:pt x="0" y="22860"/>
                    </a:lnTo>
                    <a:lnTo>
                      <a:pt x="114300" y="34290"/>
                    </a:lnTo>
                    <a:cubicBezTo>
                      <a:pt x="167591" y="38731"/>
                      <a:pt x="221436" y="37787"/>
                      <a:pt x="274320" y="45720"/>
                    </a:cubicBezTo>
                    <a:cubicBezTo>
                      <a:pt x="298150" y="49294"/>
                      <a:pt x="320040" y="60960"/>
                      <a:pt x="342900" y="68580"/>
                    </a:cubicBezTo>
                    <a:lnTo>
                      <a:pt x="377190" y="80010"/>
                    </a:lnTo>
                    <a:lnTo>
                      <a:pt x="411480" y="91440"/>
                    </a:lnTo>
                    <a:cubicBezTo>
                      <a:pt x="419100" y="102870"/>
                      <a:pt x="423613" y="117148"/>
                      <a:pt x="434340" y="125730"/>
                    </a:cubicBezTo>
                    <a:cubicBezTo>
                      <a:pt x="443748" y="133256"/>
                      <a:pt x="461104" y="127752"/>
                      <a:pt x="468630" y="137160"/>
                    </a:cubicBezTo>
                    <a:cubicBezTo>
                      <a:pt x="478443" y="149427"/>
                      <a:pt x="475744" y="167775"/>
                      <a:pt x="480060" y="182880"/>
                    </a:cubicBezTo>
                    <a:cubicBezTo>
                      <a:pt x="483370" y="194465"/>
                      <a:pt x="487680" y="205740"/>
                      <a:pt x="491490" y="217170"/>
                    </a:cubicBezTo>
                    <a:cubicBezTo>
                      <a:pt x="487680" y="255270"/>
                      <a:pt x="492168" y="295145"/>
                      <a:pt x="480060" y="331470"/>
                    </a:cubicBezTo>
                    <a:cubicBezTo>
                      <a:pt x="475716" y="344502"/>
                      <a:pt x="459507" y="354330"/>
                      <a:pt x="445770" y="354330"/>
                    </a:cubicBezTo>
                    <a:cubicBezTo>
                      <a:pt x="361604" y="354330"/>
                      <a:pt x="278130" y="339090"/>
                      <a:pt x="194310" y="331470"/>
                    </a:cubicBezTo>
                    <a:cubicBezTo>
                      <a:pt x="179588" y="287304"/>
                      <a:pt x="180645" y="295201"/>
                      <a:pt x="171450" y="240030"/>
                    </a:cubicBezTo>
                    <a:cubicBezTo>
                      <a:pt x="167021" y="213456"/>
                      <a:pt x="167109" y="186011"/>
                      <a:pt x="160020" y="160020"/>
                    </a:cubicBezTo>
                    <a:cubicBezTo>
                      <a:pt x="155537" y="143582"/>
                      <a:pt x="145614" y="129094"/>
                      <a:pt x="137160" y="114300"/>
                    </a:cubicBezTo>
                    <a:cubicBezTo>
                      <a:pt x="130344" y="102373"/>
                      <a:pt x="125027" y="88592"/>
                      <a:pt x="114300" y="80010"/>
                    </a:cubicBezTo>
                    <a:cubicBezTo>
                      <a:pt x="104892" y="72484"/>
                      <a:pt x="91440" y="72390"/>
                      <a:pt x="80010" y="68580"/>
                    </a:cubicBezTo>
                    <a:cubicBezTo>
                      <a:pt x="76200" y="57150"/>
                      <a:pt x="73968" y="45066"/>
                      <a:pt x="68580" y="34290"/>
                    </a:cubicBezTo>
                    <a:cubicBezTo>
                      <a:pt x="62437" y="22003"/>
                      <a:pt x="45720" y="0"/>
                      <a:pt x="45720" y="0"/>
                    </a:cubicBezTo>
                    <a:lnTo>
                      <a:pt x="160020" y="91440"/>
                    </a:lnTo>
                  </a:path>
                </a:pathLst>
              </a:custGeom>
              <a:solidFill>
                <a:schemeClr val="bg1"/>
              </a:solidFill>
              <a:ln w="952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68580" tIns="34290" rIns="68580" bIns="34290" numCol="1" rtlCol="0" anchor="t" anchorCtr="0" compatLnSpc="1">
                <a:prstTxWarp prst="textNoShape">
                  <a:avLst/>
                </a:prstTxWarp>
              </a:bodyPr>
              <a:lstStyle/>
              <a:p>
                <a:pPr defTabSz="68580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endParaRPr kumimoji="0" lang="ja-JP" altLang="en-US" sz="1350">
                  <a:latin typeface="Arial" charset="0"/>
                  <a:ea typeface="ＭＳ Ｐゴシック" charset="-128"/>
                </a:endParaRPr>
              </a:p>
            </p:txBody>
          </p:sp>
          <p:sp>
            <p:nvSpPr>
              <p:cNvPr id="51" name="フリーフォーム 50"/>
              <p:cNvSpPr/>
              <p:nvPr/>
            </p:nvSpPr>
            <p:spPr bwMode="auto">
              <a:xfrm>
                <a:off x="6160770" y="4286250"/>
                <a:ext cx="665053" cy="365760"/>
              </a:xfrm>
              <a:custGeom>
                <a:avLst/>
                <a:gdLst>
                  <a:gd name="connsiteX0" fmla="*/ 80010 w 665053"/>
                  <a:gd name="connsiteY0" fmla="*/ 0 h 365760"/>
                  <a:gd name="connsiteX1" fmla="*/ 80010 w 665053"/>
                  <a:gd name="connsiteY1" fmla="*/ 0 h 365760"/>
                  <a:gd name="connsiteX2" fmla="*/ 502920 w 665053"/>
                  <a:gd name="connsiteY2" fmla="*/ 11430 h 365760"/>
                  <a:gd name="connsiteX3" fmla="*/ 594360 w 665053"/>
                  <a:gd name="connsiteY3" fmla="*/ 34290 h 365760"/>
                  <a:gd name="connsiteX4" fmla="*/ 640080 w 665053"/>
                  <a:gd name="connsiteY4" fmla="*/ 45720 h 365760"/>
                  <a:gd name="connsiteX5" fmla="*/ 662940 w 665053"/>
                  <a:gd name="connsiteY5" fmla="*/ 80010 h 365760"/>
                  <a:gd name="connsiteX6" fmla="*/ 628650 w 665053"/>
                  <a:gd name="connsiteY6" fmla="*/ 262890 h 365760"/>
                  <a:gd name="connsiteX7" fmla="*/ 537210 w 665053"/>
                  <a:gd name="connsiteY7" fmla="*/ 285750 h 365760"/>
                  <a:gd name="connsiteX8" fmla="*/ 457200 w 665053"/>
                  <a:gd name="connsiteY8" fmla="*/ 320040 h 365760"/>
                  <a:gd name="connsiteX9" fmla="*/ 365760 w 665053"/>
                  <a:gd name="connsiteY9" fmla="*/ 331470 h 365760"/>
                  <a:gd name="connsiteX10" fmla="*/ 217170 w 665053"/>
                  <a:gd name="connsiteY10" fmla="*/ 354330 h 365760"/>
                  <a:gd name="connsiteX11" fmla="*/ 182880 w 665053"/>
                  <a:gd name="connsiteY11" fmla="*/ 365760 h 365760"/>
                  <a:gd name="connsiteX12" fmla="*/ 80010 w 665053"/>
                  <a:gd name="connsiteY12" fmla="*/ 354330 h 365760"/>
                  <a:gd name="connsiteX13" fmla="*/ 57150 w 665053"/>
                  <a:gd name="connsiteY13" fmla="*/ 308610 h 365760"/>
                  <a:gd name="connsiteX14" fmla="*/ 0 w 665053"/>
                  <a:gd name="connsiteY14" fmla="*/ 205740 h 365760"/>
                  <a:gd name="connsiteX15" fmla="*/ 11430 w 665053"/>
                  <a:gd name="connsiteY15" fmla="*/ 34290 h 365760"/>
                  <a:gd name="connsiteX16" fmla="*/ 11430 w 665053"/>
                  <a:gd name="connsiteY16" fmla="*/ 34290 h 3657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</a:cxnLst>
                <a:rect l="l" t="t" r="r" b="b"/>
                <a:pathLst>
                  <a:path w="665053" h="365760">
                    <a:moveTo>
                      <a:pt x="80010" y="0"/>
                    </a:moveTo>
                    <a:lnTo>
                      <a:pt x="80010" y="0"/>
                    </a:lnTo>
                    <a:cubicBezTo>
                      <a:pt x="220980" y="3810"/>
                      <a:pt x="362058" y="4722"/>
                      <a:pt x="502920" y="11430"/>
                    </a:cubicBezTo>
                    <a:cubicBezTo>
                      <a:pt x="544749" y="13422"/>
                      <a:pt x="558468" y="24035"/>
                      <a:pt x="594360" y="34290"/>
                    </a:cubicBezTo>
                    <a:cubicBezTo>
                      <a:pt x="609465" y="38606"/>
                      <a:pt x="624840" y="41910"/>
                      <a:pt x="640080" y="45720"/>
                    </a:cubicBezTo>
                    <a:cubicBezTo>
                      <a:pt x="647700" y="57150"/>
                      <a:pt x="662083" y="66300"/>
                      <a:pt x="662940" y="80010"/>
                    </a:cubicBezTo>
                    <a:cubicBezTo>
                      <a:pt x="664409" y="103516"/>
                      <a:pt x="675207" y="225644"/>
                      <a:pt x="628650" y="262890"/>
                    </a:cubicBezTo>
                    <a:cubicBezTo>
                      <a:pt x="616934" y="272263"/>
                      <a:pt x="540056" y="285181"/>
                      <a:pt x="537210" y="285750"/>
                    </a:cubicBezTo>
                    <a:cubicBezTo>
                      <a:pt x="514691" y="297009"/>
                      <a:pt x="483629" y="315235"/>
                      <a:pt x="457200" y="320040"/>
                    </a:cubicBezTo>
                    <a:cubicBezTo>
                      <a:pt x="426978" y="325535"/>
                      <a:pt x="396240" y="327660"/>
                      <a:pt x="365760" y="331470"/>
                    </a:cubicBezTo>
                    <a:cubicBezTo>
                      <a:pt x="283224" y="358982"/>
                      <a:pt x="381345" y="329072"/>
                      <a:pt x="217170" y="354330"/>
                    </a:cubicBezTo>
                    <a:cubicBezTo>
                      <a:pt x="205262" y="356162"/>
                      <a:pt x="194310" y="361950"/>
                      <a:pt x="182880" y="365760"/>
                    </a:cubicBezTo>
                    <a:cubicBezTo>
                      <a:pt x="148590" y="361950"/>
                      <a:pt x="111419" y="368607"/>
                      <a:pt x="80010" y="354330"/>
                    </a:cubicBezTo>
                    <a:cubicBezTo>
                      <a:pt x="64498" y="347279"/>
                      <a:pt x="65916" y="323221"/>
                      <a:pt x="57150" y="308610"/>
                    </a:cubicBezTo>
                    <a:cubicBezTo>
                      <a:pt x="-1804" y="210354"/>
                      <a:pt x="22991" y="274712"/>
                      <a:pt x="0" y="205740"/>
                    </a:cubicBezTo>
                    <a:lnTo>
                      <a:pt x="11430" y="34290"/>
                    </a:lnTo>
                    <a:lnTo>
                      <a:pt x="11430" y="34290"/>
                    </a:lnTo>
                  </a:path>
                </a:pathLst>
              </a:custGeom>
              <a:solidFill>
                <a:schemeClr val="bg1"/>
              </a:solidFill>
              <a:ln w="952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68580" tIns="34290" rIns="68580" bIns="34290" numCol="1" rtlCol="0" anchor="t" anchorCtr="0" compatLnSpc="1">
                <a:prstTxWarp prst="textNoShape">
                  <a:avLst/>
                </a:prstTxWarp>
              </a:bodyPr>
              <a:lstStyle/>
              <a:p>
                <a:pPr defTabSz="68580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endParaRPr kumimoji="0" lang="ja-JP" altLang="en-US" sz="1350">
                  <a:latin typeface="Arial" charset="0"/>
                  <a:ea typeface="ＭＳ Ｐゴシック" charset="-128"/>
                </a:endParaRPr>
              </a:p>
            </p:txBody>
          </p:sp>
        </p:grpSp>
        <p:sp>
          <p:nvSpPr>
            <p:cNvPr id="40" name="テキスト ボックス 39"/>
            <p:cNvSpPr txBox="1"/>
            <p:nvPr/>
          </p:nvSpPr>
          <p:spPr>
            <a:xfrm>
              <a:off x="8128283" y="4950836"/>
              <a:ext cx="387655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dirty="0">
                  <a:solidFill>
                    <a:srgbClr val="FF0000"/>
                  </a:solidFill>
                </a:rPr>
                <a:t>＊</a:t>
              </a:r>
            </a:p>
          </p:txBody>
        </p:sp>
        <p:sp>
          <p:nvSpPr>
            <p:cNvPr id="41" name="テキスト ボックス 40"/>
            <p:cNvSpPr txBox="1"/>
            <p:nvPr/>
          </p:nvSpPr>
          <p:spPr>
            <a:xfrm>
              <a:off x="7689954" y="5714800"/>
              <a:ext cx="288032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dirty="0">
                  <a:solidFill>
                    <a:srgbClr val="FF0000"/>
                  </a:solidFill>
                </a:rPr>
                <a:t>＊</a:t>
              </a:r>
            </a:p>
          </p:txBody>
        </p:sp>
        <p:sp>
          <p:nvSpPr>
            <p:cNvPr id="42" name="テキスト ボックス 41"/>
            <p:cNvSpPr txBox="1"/>
            <p:nvPr/>
          </p:nvSpPr>
          <p:spPr>
            <a:xfrm>
              <a:off x="7195548" y="5379017"/>
              <a:ext cx="288032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dirty="0">
                  <a:solidFill>
                    <a:srgbClr val="FF0000"/>
                  </a:solidFill>
                </a:rPr>
                <a:t>＊</a:t>
              </a:r>
            </a:p>
          </p:txBody>
        </p:sp>
        <p:cxnSp>
          <p:nvCxnSpPr>
            <p:cNvPr id="43" name="直線コネクタ 42"/>
            <p:cNvCxnSpPr/>
            <p:nvPr/>
          </p:nvCxnSpPr>
          <p:spPr bwMode="auto">
            <a:xfrm flipH="1" flipV="1">
              <a:off x="8407418" y="5269155"/>
              <a:ext cx="420466" cy="1226073"/>
            </a:xfrm>
            <a:prstGeom prst="line">
              <a:avLst/>
            </a:prstGeom>
            <a:solidFill>
              <a:schemeClr val="accent1"/>
            </a:solidFill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44" name="テキスト ボックス 43"/>
            <p:cNvSpPr txBox="1"/>
            <p:nvPr/>
          </p:nvSpPr>
          <p:spPr>
            <a:xfrm>
              <a:off x="8652466" y="6429740"/>
              <a:ext cx="628080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en-US" altLang="ja-JP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lang="ja-JP" alt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5" name="直線コネクタ 44"/>
            <p:cNvCxnSpPr/>
            <p:nvPr/>
          </p:nvCxnSpPr>
          <p:spPr bwMode="auto">
            <a:xfrm flipH="1">
              <a:off x="7900810" y="6042727"/>
              <a:ext cx="63771" cy="866547"/>
            </a:xfrm>
            <a:prstGeom prst="line">
              <a:avLst/>
            </a:prstGeom>
            <a:solidFill>
              <a:schemeClr val="accent1"/>
            </a:solidFill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46" name="テキスト ボックス 45"/>
            <p:cNvSpPr txBox="1"/>
            <p:nvPr/>
          </p:nvSpPr>
          <p:spPr>
            <a:xfrm>
              <a:off x="7653571" y="6837332"/>
              <a:ext cx="686091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en-US" altLang="ja-JP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lang="ja-JP" alt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7" name="直線コネクタ 46"/>
            <p:cNvCxnSpPr/>
            <p:nvPr/>
          </p:nvCxnSpPr>
          <p:spPr bwMode="auto">
            <a:xfrm>
              <a:off x="6946017" y="5583360"/>
              <a:ext cx="441958" cy="26684"/>
            </a:xfrm>
            <a:prstGeom prst="line">
              <a:avLst/>
            </a:prstGeom>
            <a:solidFill>
              <a:schemeClr val="accent1"/>
            </a:solidFill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48" name="テキスト ボックス 47"/>
            <p:cNvSpPr txBox="1"/>
            <p:nvPr/>
          </p:nvSpPr>
          <p:spPr>
            <a:xfrm>
              <a:off x="6382991" y="5329212"/>
              <a:ext cx="742276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en-US" altLang="ja-JP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ja-JP" alt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2" name="グループ化 51"/>
          <p:cNvGrpSpPr/>
          <p:nvPr/>
        </p:nvGrpSpPr>
        <p:grpSpPr>
          <a:xfrm>
            <a:off x="3445540" y="703830"/>
            <a:ext cx="2098356" cy="2520000"/>
            <a:chOff x="6118421" y="2588616"/>
            <a:chExt cx="2797809" cy="3541427"/>
          </a:xfrm>
        </p:grpSpPr>
        <p:pic>
          <p:nvPicPr>
            <p:cNvPr id="53" name="Picture 3"/>
            <p:cNvPicPr>
              <a:picLocks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228" t="39546" r="45663" b="27391"/>
            <a:stretch/>
          </p:blipFill>
          <p:spPr>
            <a:xfrm>
              <a:off x="6118421" y="2588616"/>
              <a:ext cx="2754405" cy="3541427"/>
            </a:xfrm>
            <a:prstGeom prst="rect">
              <a:avLst/>
            </a:prstGeom>
          </p:spPr>
        </p:pic>
        <p:sp>
          <p:nvSpPr>
            <p:cNvPr id="55" name="テキスト ボックス 54"/>
            <p:cNvSpPr txBox="1"/>
            <p:nvPr/>
          </p:nvSpPr>
          <p:spPr>
            <a:xfrm>
              <a:off x="7128047" y="3527645"/>
              <a:ext cx="462132" cy="5190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dirty="0">
                  <a:solidFill>
                    <a:srgbClr val="FF0000"/>
                  </a:solidFill>
                </a:rPr>
                <a:t>＊</a:t>
              </a:r>
            </a:p>
          </p:txBody>
        </p:sp>
        <p:cxnSp>
          <p:nvCxnSpPr>
            <p:cNvPr id="56" name="直線コネクタ 55"/>
            <p:cNvCxnSpPr/>
            <p:nvPr/>
          </p:nvCxnSpPr>
          <p:spPr bwMode="auto">
            <a:xfrm flipH="1">
              <a:off x="7456206" y="3111433"/>
              <a:ext cx="719995" cy="262170"/>
            </a:xfrm>
            <a:prstGeom prst="line">
              <a:avLst/>
            </a:prstGeom>
            <a:solidFill>
              <a:schemeClr val="accent1"/>
            </a:solidFill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57" name="テキスト ボックス 56"/>
            <p:cNvSpPr txBox="1"/>
            <p:nvPr/>
          </p:nvSpPr>
          <p:spPr>
            <a:xfrm>
              <a:off x="8103271" y="2831284"/>
              <a:ext cx="812959" cy="5190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en-US" altLang="ja-JP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8" name="直線コネクタ 57"/>
            <p:cNvCxnSpPr/>
            <p:nvPr/>
          </p:nvCxnSpPr>
          <p:spPr bwMode="auto">
            <a:xfrm flipV="1">
              <a:off x="6970737" y="3843318"/>
              <a:ext cx="380948" cy="895562"/>
            </a:xfrm>
            <a:prstGeom prst="line">
              <a:avLst/>
            </a:prstGeom>
            <a:solidFill>
              <a:schemeClr val="accent1"/>
            </a:solidFill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59" name="テキスト ボックス 58"/>
            <p:cNvSpPr txBox="1"/>
            <p:nvPr/>
          </p:nvSpPr>
          <p:spPr>
            <a:xfrm>
              <a:off x="6370113" y="4625404"/>
              <a:ext cx="1067495" cy="5190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en-US" altLang="ja-JP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+c</a:t>
              </a:r>
              <a:endPara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0" name="タイトル 1"/>
          <p:cNvSpPr txBox="1">
            <a:spLocks/>
          </p:cNvSpPr>
          <p:nvPr/>
        </p:nvSpPr>
        <p:spPr>
          <a:xfrm>
            <a:off x="164119" y="16211"/>
            <a:ext cx="3064632" cy="71153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</a:t>
            </a:r>
            <a:r>
              <a:rPr lang="en-US" altLang="ja-JP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r>
              <a:rPr lang="en-US" altLang="ja-JP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26905" y="526650"/>
            <a:ext cx="37596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3200" dirty="0"/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3060732" y="540821"/>
            <a:ext cx="37596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3200" dirty="0"/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30445" y="3656174"/>
            <a:ext cx="37596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3200" dirty="0"/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3053646" y="3670350"/>
            <a:ext cx="37596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kumimoji="1" lang="ja-JP" altLang="en-US" sz="3200" dirty="0"/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6119376" y="3663259"/>
            <a:ext cx="37596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kumimoji="1" lang="ja-JP" altLang="en-US" sz="3200" dirty="0"/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4167751" y="3281836"/>
            <a:ext cx="252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wo stems; 2.2%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476842" y="3286019"/>
            <a:ext cx="252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ngle stem; 97.8%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173654" y="6416844"/>
            <a:ext cx="28404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B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B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ype; 80.4%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3228751" y="6441653"/>
            <a:ext cx="28495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B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B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ype; 15.2%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6088918" y="6441651"/>
            <a:ext cx="30869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B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B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ype; 4.4%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4" name="Picture 2"/>
          <p:cNvPicPr>
            <a:picLocks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395" t="19196" r="38200" b="33645"/>
          <a:stretch/>
        </p:blipFill>
        <p:spPr bwMode="auto">
          <a:xfrm>
            <a:off x="324125" y="700859"/>
            <a:ext cx="2520000" cy="252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9" name="テキスト ボックス 68"/>
          <p:cNvSpPr txBox="1"/>
          <p:nvPr/>
        </p:nvSpPr>
        <p:spPr>
          <a:xfrm>
            <a:off x="1296798" y="1416497"/>
            <a:ext cx="3708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>
                <a:solidFill>
                  <a:srgbClr val="FF0000"/>
                </a:solidFill>
              </a:rPr>
              <a:t>＊</a:t>
            </a:r>
          </a:p>
        </p:txBody>
      </p:sp>
      <p:cxnSp>
        <p:nvCxnSpPr>
          <p:cNvPr id="70" name="直線コネクタ 69"/>
          <p:cNvCxnSpPr/>
          <p:nvPr/>
        </p:nvCxnSpPr>
        <p:spPr bwMode="auto">
          <a:xfrm flipH="1" flipV="1">
            <a:off x="1553277" y="1621638"/>
            <a:ext cx="829102" cy="504930"/>
          </a:xfrm>
          <a:prstGeom prst="line">
            <a:avLst/>
          </a:prstGeom>
          <a:solidFill>
            <a:schemeClr val="accent1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75" name="テキスト ボックス 74"/>
          <p:cNvSpPr txBox="1"/>
          <p:nvPr/>
        </p:nvSpPr>
        <p:spPr>
          <a:xfrm>
            <a:off x="2317068" y="2051243"/>
            <a:ext cx="4580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8" name="Picture 3"/>
          <p:cNvPicPr>
            <a:picLocks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638" t="37280" r="53167" b="27845"/>
          <a:stretch/>
        </p:blipFill>
        <p:spPr>
          <a:xfrm>
            <a:off x="5545843" y="707830"/>
            <a:ext cx="1745672" cy="2520000"/>
          </a:xfrm>
          <a:prstGeom prst="rect">
            <a:avLst/>
          </a:prstGeom>
        </p:spPr>
      </p:pic>
      <p:sp>
        <p:nvSpPr>
          <p:cNvPr id="76" name="テキスト ボックス 75"/>
          <p:cNvSpPr txBox="1"/>
          <p:nvPr/>
        </p:nvSpPr>
        <p:spPr>
          <a:xfrm>
            <a:off x="6426956" y="912961"/>
            <a:ext cx="3708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>
                <a:solidFill>
                  <a:schemeClr val="bg1"/>
                </a:solidFill>
              </a:rPr>
              <a:t>＊</a:t>
            </a:r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6318388" y="1261300"/>
            <a:ext cx="3708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>
                <a:solidFill>
                  <a:schemeClr val="bg1"/>
                </a:solidFill>
              </a:rPr>
              <a:t>＊</a:t>
            </a:r>
          </a:p>
        </p:txBody>
      </p:sp>
      <p:sp>
        <p:nvSpPr>
          <p:cNvPr id="78" name="テキスト ボックス 77"/>
          <p:cNvSpPr txBox="1"/>
          <p:nvPr/>
        </p:nvSpPr>
        <p:spPr>
          <a:xfrm>
            <a:off x="6838079" y="2397009"/>
            <a:ext cx="554290" cy="30523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9" name="直線コネクタ 78"/>
          <p:cNvCxnSpPr/>
          <p:nvPr/>
        </p:nvCxnSpPr>
        <p:spPr bwMode="auto">
          <a:xfrm flipH="1" flipV="1">
            <a:off x="6634594" y="1120893"/>
            <a:ext cx="370551" cy="1322368"/>
          </a:xfrm>
          <a:prstGeom prst="line">
            <a:avLst/>
          </a:prstGeom>
          <a:solidFill>
            <a:schemeClr val="accent1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80" name="テキスト ボックス 79"/>
          <p:cNvSpPr txBox="1"/>
          <p:nvPr/>
        </p:nvSpPr>
        <p:spPr>
          <a:xfrm>
            <a:off x="5421393" y="2250527"/>
            <a:ext cx="800621" cy="3052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+c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1" name="直線コネクタ 80"/>
          <p:cNvCxnSpPr/>
          <p:nvPr/>
        </p:nvCxnSpPr>
        <p:spPr bwMode="auto">
          <a:xfrm flipV="1">
            <a:off x="5733297" y="1487816"/>
            <a:ext cx="768866" cy="807663"/>
          </a:xfrm>
          <a:prstGeom prst="line">
            <a:avLst/>
          </a:prstGeom>
          <a:solidFill>
            <a:schemeClr val="accent1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82" name="テキスト ボックス 81"/>
          <p:cNvSpPr txBox="1"/>
          <p:nvPr/>
        </p:nvSpPr>
        <p:spPr>
          <a:xfrm>
            <a:off x="4202757" y="1053830"/>
            <a:ext cx="3465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>
                <a:solidFill>
                  <a:srgbClr val="FF0000"/>
                </a:solidFill>
              </a:rPr>
              <a:t>＊</a:t>
            </a:r>
          </a:p>
        </p:txBody>
      </p:sp>
      <p:sp>
        <p:nvSpPr>
          <p:cNvPr id="84" name="テキスト ボックス 83"/>
          <p:cNvSpPr txBox="1"/>
          <p:nvPr/>
        </p:nvSpPr>
        <p:spPr>
          <a:xfrm>
            <a:off x="5599160" y="1045810"/>
            <a:ext cx="609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5" name="直線コネクタ 84"/>
          <p:cNvCxnSpPr/>
          <p:nvPr/>
        </p:nvCxnSpPr>
        <p:spPr bwMode="auto">
          <a:xfrm flipH="1" flipV="1">
            <a:off x="6058376" y="1197621"/>
            <a:ext cx="508405" cy="1877"/>
          </a:xfrm>
          <a:prstGeom prst="line">
            <a:avLst/>
          </a:prstGeom>
          <a:solidFill>
            <a:schemeClr val="accent1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88" name="テキスト ボックス 87"/>
          <p:cNvSpPr txBox="1"/>
          <p:nvPr/>
        </p:nvSpPr>
        <p:spPr>
          <a:xfrm>
            <a:off x="5538343" y="2976059"/>
            <a:ext cx="800620" cy="30523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+c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9" name="直線コネクタ 88"/>
          <p:cNvCxnSpPr/>
          <p:nvPr/>
        </p:nvCxnSpPr>
        <p:spPr bwMode="auto">
          <a:xfrm flipV="1">
            <a:off x="6039749" y="1725453"/>
            <a:ext cx="438018" cy="1255281"/>
          </a:xfrm>
          <a:prstGeom prst="line">
            <a:avLst/>
          </a:prstGeom>
          <a:solidFill>
            <a:schemeClr val="accent1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2" name="角丸四角形 1"/>
          <p:cNvSpPr/>
          <p:nvPr/>
        </p:nvSpPr>
        <p:spPr>
          <a:xfrm>
            <a:off x="1994263" y="3843110"/>
            <a:ext cx="1002579" cy="580844"/>
          </a:xfrm>
          <a:prstGeom prst="round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3" name="角丸四角形 82"/>
          <p:cNvSpPr/>
          <p:nvPr/>
        </p:nvSpPr>
        <p:spPr>
          <a:xfrm>
            <a:off x="5298870" y="3813014"/>
            <a:ext cx="733206" cy="580844"/>
          </a:xfrm>
          <a:prstGeom prst="round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6" name="角丸四角形 85"/>
          <p:cNvSpPr/>
          <p:nvPr/>
        </p:nvSpPr>
        <p:spPr>
          <a:xfrm>
            <a:off x="8313987" y="3827008"/>
            <a:ext cx="733206" cy="580844"/>
          </a:xfrm>
          <a:prstGeom prst="round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24535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358</Words>
  <Application>Microsoft Office PowerPoint</Application>
  <PresentationFormat>画面に合わせる (4:3)</PresentationFormat>
  <Paragraphs>205</Paragraphs>
  <Slides>8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8</vt:i4>
      </vt:variant>
    </vt:vector>
  </HeadingPairs>
  <TitlesOfParts>
    <vt:vector size="14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Supplemental Figure </vt:lpstr>
      <vt:lpstr>Supplemental Fig.1 </vt:lpstr>
      <vt:lpstr>Supplemental Fig.2</vt:lpstr>
      <vt:lpstr>Supplemental Fig.3 </vt:lpstr>
      <vt:lpstr>Supplemental Fig.4 </vt:lpstr>
      <vt:lpstr>Supplemental Fig. 5 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 </dc:title>
  <dc:creator>Toshiteru</dc:creator>
  <cp:lastModifiedBy>Toshiteru</cp:lastModifiedBy>
  <cp:revision>1</cp:revision>
  <dcterms:created xsi:type="dcterms:W3CDTF">2016-11-14T11:46:13Z</dcterms:created>
  <dcterms:modified xsi:type="dcterms:W3CDTF">2016-11-14T11:47:18Z</dcterms:modified>
</cp:coreProperties>
</file>